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738" r:id="rId1"/>
  </p:sldMasterIdLst>
  <p:notesMasterIdLst>
    <p:notesMasterId r:id="rId13"/>
  </p:notesMasterIdLst>
  <p:sldIdLst>
    <p:sldId id="256" r:id="rId2"/>
    <p:sldId id="257" r:id="rId3"/>
    <p:sldId id="267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68"/>
    <p:restoredTop sz="85714"/>
  </p:normalViewPr>
  <p:slideViewPr>
    <p:cSldViewPr snapToGrid="0">
      <p:cViewPr varScale="1">
        <p:scale>
          <a:sx n="145" d="100"/>
          <a:sy n="145" d="100"/>
        </p:scale>
        <p:origin x="1080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5D82D10-4C62-47AC-A661-ADB649EC5146}" type="doc">
      <dgm:prSet loTypeId="urn:microsoft.com/office/officeart/2005/8/layout/default" loCatId="list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9F06C56A-AA89-412E-9B23-D48CC3F69F8D}">
      <dgm:prSet/>
      <dgm:spPr/>
      <dgm:t>
        <a:bodyPr/>
        <a:lstStyle/>
        <a:p>
          <a:r>
            <a:rPr lang="en-US"/>
            <a:t>Congenital myopathy</a:t>
          </a:r>
        </a:p>
      </dgm:t>
    </dgm:pt>
    <dgm:pt modelId="{AE6190F9-A6F6-4861-A922-4B21073A0868}" type="parTrans" cxnId="{615106ED-FA95-430D-8E7A-B3BBD5189D23}">
      <dgm:prSet/>
      <dgm:spPr/>
      <dgm:t>
        <a:bodyPr/>
        <a:lstStyle/>
        <a:p>
          <a:endParaRPr lang="en-US"/>
        </a:p>
      </dgm:t>
    </dgm:pt>
    <dgm:pt modelId="{788F3F47-FB2E-460B-8B51-F7054BE13484}" type="sibTrans" cxnId="{615106ED-FA95-430D-8E7A-B3BBD5189D23}">
      <dgm:prSet/>
      <dgm:spPr/>
      <dgm:t>
        <a:bodyPr/>
        <a:lstStyle/>
        <a:p>
          <a:endParaRPr lang="en-US"/>
        </a:p>
      </dgm:t>
    </dgm:pt>
    <dgm:pt modelId="{81136B25-FEFA-4BEA-99CD-D8B9C2E36240}">
      <dgm:prSet/>
      <dgm:spPr/>
      <dgm:t>
        <a:bodyPr/>
        <a:lstStyle/>
        <a:p>
          <a:r>
            <a:rPr lang="en-US"/>
            <a:t>Electrolyte imbalance/dehydration (hypoglycemia, hyponatremia, hyperkalemia)</a:t>
          </a:r>
        </a:p>
      </dgm:t>
    </dgm:pt>
    <dgm:pt modelId="{A34F50BE-8708-4DF5-B847-A72139D76844}" type="parTrans" cxnId="{58B416FA-8B81-435E-BA8A-D2E604DB6839}">
      <dgm:prSet/>
      <dgm:spPr/>
      <dgm:t>
        <a:bodyPr/>
        <a:lstStyle/>
        <a:p>
          <a:endParaRPr lang="en-US"/>
        </a:p>
      </dgm:t>
    </dgm:pt>
    <dgm:pt modelId="{71F05110-D27A-422A-AAB1-203D088468F0}" type="sibTrans" cxnId="{58B416FA-8B81-435E-BA8A-D2E604DB6839}">
      <dgm:prSet/>
      <dgm:spPr/>
      <dgm:t>
        <a:bodyPr/>
        <a:lstStyle/>
        <a:p>
          <a:endParaRPr lang="en-US"/>
        </a:p>
      </dgm:t>
    </dgm:pt>
    <dgm:pt modelId="{400C9BDD-1F9B-4544-8A3D-60F38E9D6C5C}">
      <dgm:prSet/>
      <dgm:spPr/>
      <dgm:t>
        <a:bodyPr/>
        <a:lstStyle/>
        <a:p>
          <a:r>
            <a:rPr lang="en-US"/>
            <a:t>Guillain-Barre syndrome</a:t>
          </a:r>
        </a:p>
      </dgm:t>
    </dgm:pt>
    <dgm:pt modelId="{9C7F3D81-C482-43C1-9D2A-428743110162}" type="parTrans" cxnId="{5A944E5D-8DDB-4F02-A6AF-2E0950F45328}">
      <dgm:prSet/>
      <dgm:spPr/>
      <dgm:t>
        <a:bodyPr/>
        <a:lstStyle/>
        <a:p>
          <a:endParaRPr lang="en-US"/>
        </a:p>
      </dgm:t>
    </dgm:pt>
    <dgm:pt modelId="{F7D1EBA2-CDDE-4592-A168-9D4CACBA39E0}" type="sibTrans" cxnId="{5A944E5D-8DDB-4F02-A6AF-2E0950F45328}">
      <dgm:prSet/>
      <dgm:spPr/>
      <dgm:t>
        <a:bodyPr/>
        <a:lstStyle/>
        <a:p>
          <a:endParaRPr lang="en-US"/>
        </a:p>
      </dgm:t>
    </dgm:pt>
    <dgm:pt modelId="{FF14BFD9-900D-41C9-808E-9DA9F74952C5}">
      <dgm:prSet/>
      <dgm:spPr/>
      <dgm:t>
        <a:bodyPr/>
        <a:lstStyle/>
        <a:p>
          <a:r>
            <a:rPr lang="en-US" dirty="0"/>
            <a:t>Intoxication / Drug Side Effect (ie, Ingestion of sedating medications or marijuana, etc.)</a:t>
          </a:r>
        </a:p>
      </dgm:t>
    </dgm:pt>
    <dgm:pt modelId="{1A2A6324-8B10-468D-BB71-5B0B29EA6271}" type="parTrans" cxnId="{C03494CC-8E05-48C1-84A0-BF2F0C24DBA7}">
      <dgm:prSet/>
      <dgm:spPr/>
      <dgm:t>
        <a:bodyPr/>
        <a:lstStyle/>
        <a:p>
          <a:endParaRPr lang="en-US"/>
        </a:p>
      </dgm:t>
    </dgm:pt>
    <dgm:pt modelId="{0B980722-32F8-4471-8C8C-8519C5EFDEE7}" type="sibTrans" cxnId="{C03494CC-8E05-48C1-84A0-BF2F0C24DBA7}">
      <dgm:prSet/>
      <dgm:spPr/>
      <dgm:t>
        <a:bodyPr/>
        <a:lstStyle/>
        <a:p>
          <a:endParaRPr lang="en-US"/>
        </a:p>
      </dgm:t>
    </dgm:pt>
    <dgm:pt modelId="{96E225D1-D32D-4476-8FD8-B24C9C06F631}">
      <dgm:prSet/>
      <dgm:spPr/>
      <dgm:t>
        <a:bodyPr/>
        <a:lstStyle/>
        <a:p>
          <a:r>
            <a:rPr lang="en-US"/>
            <a:t>Leigh disease</a:t>
          </a:r>
        </a:p>
      </dgm:t>
    </dgm:pt>
    <dgm:pt modelId="{EC5957C7-107A-4186-9DB5-F7CAA6A82FB7}" type="parTrans" cxnId="{6C9E78BE-041C-4571-BF8D-1E54CEABDFB2}">
      <dgm:prSet/>
      <dgm:spPr/>
      <dgm:t>
        <a:bodyPr/>
        <a:lstStyle/>
        <a:p>
          <a:endParaRPr lang="en-US"/>
        </a:p>
      </dgm:t>
    </dgm:pt>
    <dgm:pt modelId="{76D27C66-90D1-4C9C-B5F7-7B6E11E63743}" type="sibTrans" cxnId="{6C9E78BE-041C-4571-BF8D-1E54CEABDFB2}">
      <dgm:prSet/>
      <dgm:spPr/>
      <dgm:t>
        <a:bodyPr/>
        <a:lstStyle/>
        <a:p>
          <a:endParaRPr lang="en-US"/>
        </a:p>
      </dgm:t>
    </dgm:pt>
    <dgm:pt modelId="{C50F6E8B-1D0C-4DE1-8A06-D4EF46E98E9B}">
      <dgm:prSet/>
      <dgm:spPr/>
      <dgm:t>
        <a:bodyPr/>
        <a:lstStyle/>
        <a:p>
          <a:r>
            <a:rPr lang="en-US"/>
            <a:t>Metabolic disorder and encephalopathy</a:t>
          </a:r>
        </a:p>
      </dgm:t>
    </dgm:pt>
    <dgm:pt modelId="{2B552376-A983-4ABE-9A41-BA1FBBADB7A8}" type="parTrans" cxnId="{F7159989-762B-470B-B129-1610FD62DB72}">
      <dgm:prSet/>
      <dgm:spPr/>
      <dgm:t>
        <a:bodyPr/>
        <a:lstStyle/>
        <a:p>
          <a:endParaRPr lang="en-US"/>
        </a:p>
      </dgm:t>
    </dgm:pt>
    <dgm:pt modelId="{A6912A98-4A94-46F6-A468-8CA8BF4CD012}" type="sibTrans" cxnId="{F7159989-762B-470B-B129-1610FD62DB72}">
      <dgm:prSet/>
      <dgm:spPr/>
      <dgm:t>
        <a:bodyPr/>
        <a:lstStyle/>
        <a:p>
          <a:endParaRPr lang="en-US"/>
        </a:p>
      </dgm:t>
    </dgm:pt>
    <dgm:pt modelId="{FA488D17-B950-4056-9159-085EDD6A4172}">
      <dgm:prSet/>
      <dgm:spPr/>
      <dgm:t>
        <a:bodyPr/>
        <a:lstStyle/>
        <a:p>
          <a:r>
            <a:rPr lang="en-US"/>
            <a:t>Myasthenia gravis</a:t>
          </a:r>
        </a:p>
      </dgm:t>
    </dgm:pt>
    <dgm:pt modelId="{4AEFDE77-35FB-4721-A5B1-11C3475E7AB8}" type="parTrans" cxnId="{4BBDF3E6-0EEF-4991-B27C-8CCBA3FFC298}">
      <dgm:prSet/>
      <dgm:spPr/>
      <dgm:t>
        <a:bodyPr/>
        <a:lstStyle/>
        <a:p>
          <a:endParaRPr lang="en-US"/>
        </a:p>
      </dgm:t>
    </dgm:pt>
    <dgm:pt modelId="{FEE98CAB-7AA0-4E84-B694-E122FD89C962}" type="sibTrans" cxnId="{4BBDF3E6-0EEF-4991-B27C-8CCBA3FFC298}">
      <dgm:prSet/>
      <dgm:spPr/>
      <dgm:t>
        <a:bodyPr/>
        <a:lstStyle/>
        <a:p>
          <a:endParaRPr lang="en-US"/>
        </a:p>
      </dgm:t>
    </dgm:pt>
    <dgm:pt modelId="{F656C948-5C38-464E-9DE4-E47F63D68325}">
      <dgm:prSet/>
      <dgm:spPr/>
      <dgm:t>
        <a:bodyPr/>
        <a:lstStyle/>
        <a:p>
          <a:r>
            <a:rPr lang="en-US"/>
            <a:t>Non-accidental trauma</a:t>
          </a:r>
        </a:p>
      </dgm:t>
    </dgm:pt>
    <dgm:pt modelId="{CBA44BDB-F643-48CC-BCD6-F4CC296EE8BB}" type="parTrans" cxnId="{EF23887A-0200-4DB0-BA99-63C37959069A}">
      <dgm:prSet/>
      <dgm:spPr/>
      <dgm:t>
        <a:bodyPr/>
        <a:lstStyle/>
        <a:p>
          <a:endParaRPr lang="en-US"/>
        </a:p>
      </dgm:t>
    </dgm:pt>
    <dgm:pt modelId="{298264B6-9759-4E76-B737-DF4C7F37546B}" type="sibTrans" cxnId="{EF23887A-0200-4DB0-BA99-63C37959069A}">
      <dgm:prSet/>
      <dgm:spPr/>
      <dgm:t>
        <a:bodyPr/>
        <a:lstStyle/>
        <a:p>
          <a:endParaRPr lang="en-US"/>
        </a:p>
      </dgm:t>
    </dgm:pt>
    <dgm:pt modelId="{B7C77020-844C-4DD2-93CA-E73EBBF6BDB0}">
      <dgm:prSet/>
      <dgm:spPr/>
      <dgm:t>
        <a:bodyPr/>
        <a:lstStyle/>
        <a:p>
          <a:r>
            <a:rPr lang="en-US" dirty="0"/>
            <a:t>Sepsis (pneumonia, urinary tract infection, meningitis, or other source)</a:t>
          </a:r>
        </a:p>
      </dgm:t>
    </dgm:pt>
    <dgm:pt modelId="{75FF4A2F-9C8D-4D44-9B24-FD6FF43D6F4B}" type="parTrans" cxnId="{A4F5E0E4-7D75-4076-BE5E-330C48521F98}">
      <dgm:prSet/>
      <dgm:spPr/>
      <dgm:t>
        <a:bodyPr/>
        <a:lstStyle/>
        <a:p>
          <a:endParaRPr lang="en-US"/>
        </a:p>
      </dgm:t>
    </dgm:pt>
    <dgm:pt modelId="{B371589C-ABF3-4FF6-A310-D62FB266A7B6}" type="sibTrans" cxnId="{A4F5E0E4-7D75-4076-BE5E-330C48521F98}">
      <dgm:prSet/>
      <dgm:spPr/>
      <dgm:t>
        <a:bodyPr/>
        <a:lstStyle/>
        <a:p>
          <a:endParaRPr lang="en-US"/>
        </a:p>
      </dgm:t>
    </dgm:pt>
    <dgm:pt modelId="{6D1AC633-A897-B440-83C3-E844B7ADA26F}" type="pres">
      <dgm:prSet presAssocID="{F5D82D10-4C62-47AC-A661-ADB649EC5146}" presName="diagram" presStyleCnt="0">
        <dgm:presLayoutVars>
          <dgm:dir/>
          <dgm:resizeHandles val="exact"/>
        </dgm:presLayoutVars>
      </dgm:prSet>
      <dgm:spPr/>
    </dgm:pt>
    <dgm:pt modelId="{12446922-3DAB-404F-A66E-8AE71741814B}" type="pres">
      <dgm:prSet presAssocID="{9F06C56A-AA89-412E-9B23-D48CC3F69F8D}" presName="node" presStyleLbl="node1" presStyleIdx="0" presStyleCnt="9">
        <dgm:presLayoutVars>
          <dgm:bulletEnabled val="1"/>
        </dgm:presLayoutVars>
      </dgm:prSet>
      <dgm:spPr/>
    </dgm:pt>
    <dgm:pt modelId="{80D739DA-91C5-FF41-8DF9-3DC387481839}" type="pres">
      <dgm:prSet presAssocID="{788F3F47-FB2E-460B-8B51-F7054BE13484}" presName="sibTrans" presStyleCnt="0"/>
      <dgm:spPr/>
    </dgm:pt>
    <dgm:pt modelId="{D4BEB8B4-2AA7-9A4B-A50C-9A3119B8A781}" type="pres">
      <dgm:prSet presAssocID="{81136B25-FEFA-4BEA-99CD-D8B9C2E36240}" presName="node" presStyleLbl="node1" presStyleIdx="1" presStyleCnt="9">
        <dgm:presLayoutVars>
          <dgm:bulletEnabled val="1"/>
        </dgm:presLayoutVars>
      </dgm:prSet>
      <dgm:spPr/>
    </dgm:pt>
    <dgm:pt modelId="{C4862B99-D092-4F40-A133-8A67F9946BBD}" type="pres">
      <dgm:prSet presAssocID="{71F05110-D27A-422A-AAB1-203D088468F0}" presName="sibTrans" presStyleCnt="0"/>
      <dgm:spPr/>
    </dgm:pt>
    <dgm:pt modelId="{2DA6F284-0FD8-384E-ADD7-5C386EE89C8B}" type="pres">
      <dgm:prSet presAssocID="{400C9BDD-1F9B-4544-8A3D-60F38E9D6C5C}" presName="node" presStyleLbl="node1" presStyleIdx="2" presStyleCnt="9">
        <dgm:presLayoutVars>
          <dgm:bulletEnabled val="1"/>
        </dgm:presLayoutVars>
      </dgm:prSet>
      <dgm:spPr/>
    </dgm:pt>
    <dgm:pt modelId="{01026B9A-5179-4047-A158-3CC356AB261F}" type="pres">
      <dgm:prSet presAssocID="{F7D1EBA2-CDDE-4592-A168-9D4CACBA39E0}" presName="sibTrans" presStyleCnt="0"/>
      <dgm:spPr/>
    </dgm:pt>
    <dgm:pt modelId="{0AE6701C-D60A-A942-84F6-3612C1CA2CFB}" type="pres">
      <dgm:prSet presAssocID="{FF14BFD9-900D-41C9-808E-9DA9F74952C5}" presName="node" presStyleLbl="node1" presStyleIdx="3" presStyleCnt="9">
        <dgm:presLayoutVars>
          <dgm:bulletEnabled val="1"/>
        </dgm:presLayoutVars>
      </dgm:prSet>
      <dgm:spPr/>
    </dgm:pt>
    <dgm:pt modelId="{22071301-CB92-B740-9A70-DE06EE4E3A55}" type="pres">
      <dgm:prSet presAssocID="{0B980722-32F8-4471-8C8C-8519C5EFDEE7}" presName="sibTrans" presStyleCnt="0"/>
      <dgm:spPr/>
    </dgm:pt>
    <dgm:pt modelId="{3D2F6C50-26A8-1844-A888-42DDBD047B0D}" type="pres">
      <dgm:prSet presAssocID="{96E225D1-D32D-4476-8FD8-B24C9C06F631}" presName="node" presStyleLbl="node1" presStyleIdx="4" presStyleCnt="9">
        <dgm:presLayoutVars>
          <dgm:bulletEnabled val="1"/>
        </dgm:presLayoutVars>
      </dgm:prSet>
      <dgm:spPr/>
    </dgm:pt>
    <dgm:pt modelId="{F2436FD0-1902-0941-86D5-CB5DFF2A7197}" type="pres">
      <dgm:prSet presAssocID="{76D27C66-90D1-4C9C-B5F7-7B6E11E63743}" presName="sibTrans" presStyleCnt="0"/>
      <dgm:spPr/>
    </dgm:pt>
    <dgm:pt modelId="{A1F48A39-BE0D-6745-91E2-ADAED66E1054}" type="pres">
      <dgm:prSet presAssocID="{C50F6E8B-1D0C-4DE1-8A06-D4EF46E98E9B}" presName="node" presStyleLbl="node1" presStyleIdx="5" presStyleCnt="9">
        <dgm:presLayoutVars>
          <dgm:bulletEnabled val="1"/>
        </dgm:presLayoutVars>
      </dgm:prSet>
      <dgm:spPr/>
    </dgm:pt>
    <dgm:pt modelId="{08ABEC55-87D9-D640-99DA-40B4788B2E65}" type="pres">
      <dgm:prSet presAssocID="{A6912A98-4A94-46F6-A468-8CA8BF4CD012}" presName="sibTrans" presStyleCnt="0"/>
      <dgm:spPr/>
    </dgm:pt>
    <dgm:pt modelId="{02F99878-001D-E642-A469-234F29B3CDB7}" type="pres">
      <dgm:prSet presAssocID="{FA488D17-B950-4056-9159-085EDD6A4172}" presName="node" presStyleLbl="node1" presStyleIdx="6" presStyleCnt="9">
        <dgm:presLayoutVars>
          <dgm:bulletEnabled val="1"/>
        </dgm:presLayoutVars>
      </dgm:prSet>
      <dgm:spPr/>
    </dgm:pt>
    <dgm:pt modelId="{43792A54-9D2B-2744-893B-1584354C0BC0}" type="pres">
      <dgm:prSet presAssocID="{FEE98CAB-7AA0-4E84-B694-E122FD89C962}" presName="sibTrans" presStyleCnt="0"/>
      <dgm:spPr/>
    </dgm:pt>
    <dgm:pt modelId="{E47F9C0C-2BE2-1F4A-A067-0F215E11967B}" type="pres">
      <dgm:prSet presAssocID="{F656C948-5C38-464E-9DE4-E47F63D68325}" presName="node" presStyleLbl="node1" presStyleIdx="7" presStyleCnt="9">
        <dgm:presLayoutVars>
          <dgm:bulletEnabled val="1"/>
        </dgm:presLayoutVars>
      </dgm:prSet>
      <dgm:spPr/>
    </dgm:pt>
    <dgm:pt modelId="{A6EA4AE6-65E3-334D-A90B-BBF31F9695A6}" type="pres">
      <dgm:prSet presAssocID="{298264B6-9759-4E76-B737-DF4C7F37546B}" presName="sibTrans" presStyleCnt="0"/>
      <dgm:spPr/>
    </dgm:pt>
    <dgm:pt modelId="{FDF79936-D1CC-7E48-93A6-1073F463F0EE}" type="pres">
      <dgm:prSet presAssocID="{B7C77020-844C-4DD2-93CA-E73EBBF6BDB0}" presName="node" presStyleLbl="node1" presStyleIdx="8" presStyleCnt="9">
        <dgm:presLayoutVars>
          <dgm:bulletEnabled val="1"/>
        </dgm:presLayoutVars>
      </dgm:prSet>
      <dgm:spPr/>
    </dgm:pt>
  </dgm:ptLst>
  <dgm:cxnLst>
    <dgm:cxn modelId="{5D5A0806-0199-064E-AEE5-1E577FAAF09C}" type="presOf" srcId="{9F06C56A-AA89-412E-9B23-D48CC3F69F8D}" destId="{12446922-3DAB-404F-A66E-8AE71741814B}" srcOrd="0" destOrd="0" presId="urn:microsoft.com/office/officeart/2005/8/layout/default"/>
    <dgm:cxn modelId="{9762830D-58CF-C944-91BB-BD10083B79B9}" type="presOf" srcId="{C50F6E8B-1D0C-4DE1-8A06-D4EF46E98E9B}" destId="{A1F48A39-BE0D-6745-91E2-ADAED66E1054}" srcOrd="0" destOrd="0" presId="urn:microsoft.com/office/officeart/2005/8/layout/default"/>
    <dgm:cxn modelId="{2195FD11-A10A-2E4B-AB1B-E4AFF098AEB3}" type="presOf" srcId="{F5D82D10-4C62-47AC-A661-ADB649EC5146}" destId="{6D1AC633-A897-B440-83C3-E844B7ADA26F}" srcOrd="0" destOrd="0" presId="urn:microsoft.com/office/officeart/2005/8/layout/default"/>
    <dgm:cxn modelId="{5A944E5D-8DDB-4F02-A6AF-2E0950F45328}" srcId="{F5D82D10-4C62-47AC-A661-ADB649EC5146}" destId="{400C9BDD-1F9B-4544-8A3D-60F38E9D6C5C}" srcOrd="2" destOrd="0" parTransId="{9C7F3D81-C482-43C1-9D2A-428743110162}" sibTransId="{F7D1EBA2-CDDE-4592-A168-9D4CACBA39E0}"/>
    <dgm:cxn modelId="{003A635D-38B4-DC48-929F-F96792C94617}" type="presOf" srcId="{F656C948-5C38-464E-9DE4-E47F63D68325}" destId="{E47F9C0C-2BE2-1F4A-A067-0F215E11967B}" srcOrd="0" destOrd="0" presId="urn:microsoft.com/office/officeart/2005/8/layout/default"/>
    <dgm:cxn modelId="{B5F86062-CD0E-CB4A-874C-B141165183BC}" type="presOf" srcId="{96E225D1-D32D-4476-8FD8-B24C9C06F631}" destId="{3D2F6C50-26A8-1844-A888-42DDBD047B0D}" srcOrd="0" destOrd="0" presId="urn:microsoft.com/office/officeart/2005/8/layout/default"/>
    <dgm:cxn modelId="{96C69969-C37F-8044-8DF5-5485367A335B}" type="presOf" srcId="{400C9BDD-1F9B-4544-8A3D-60F38E9D6C5C}" destId="{2DA6F284-0FD8-384E-ADD7-5C386EE89C8B}" srcOrd="0" destOrd="0" presId="urn:microsoft.com/office/officeart/2005/8/layout/default"/>
    <dgm:cxn modelId="{EF23887A-0200-4DB0-BA99-63C37959069A}" srcId="{F5D82D10-4C62-47AC-A661-ADB649EC5146}" destId="{F656C948-5C38-464E-9DE4-E47F63D68325}" srcOrd="7" destOrd="0" parTransId="{CBA44BDB-F643-48CC-BCD6-F4CC296EE8BB}" sibTransId="{298264B6-9759-4E76-B737-DF4C7F37546B}"/>
    <dgm:cxn modelId="{F7159989-762B-470B-B129-1610FD62DB72}" srcId="{F5D82D10-4C62-47AC-A661-ADB649EC5146}" destId="{C50F6E8B-1D0C-4DE1-8A06-D4EF46E98E9B}" srcOrd="5" destOrd="0" parTransId="{2B552376-A983-4ABE-9A41-BA1FBBADB7A8}" sibTransId="{A6912A98-4A94-46F6-A468-8CA8BF4CD012}"/>
    <dgm:cxn modelId="{EF67AA90-CC9C-8B49-B9B8-F9211D7DA9C5}" type="presOf" srcId="{FF14BFD9-900D-41C9-808E-9DA9F74952C5}" destId="{0AE6701C-D60A-A942-84F6-3612C1CA2CFB}" srcOrd="0" destOrd="0" presId="urn:microsoft.com/office/officeart/2005/8/layout/default"/>
    <dgm:cxn modelId="{792A8FAB-4B29-F047-8815-2E6CEDBD5AFC}" type="presOf" srcId="{B7C77020-844C-4DD2-93CA-E73EBBF6BDB0}" destId="{FDF79936-D1CC-7E48-93A6-1073F463F0EE}" srcOrd="0" destOrd="0" presId="urn:microsoft.com/office/officeart/2005/8/layout/default"/>
    <dgm:cxn modelId="{6C9E78BE-041C-4571-BF8D-1E54CEABDFB2}" srcId="{F5D82D10-4C62-47AC-A661-ADB649EC5146}" destId="{96E225D1-D32D-4476-8FD8-B24C9C06F631}" srcOrd="4" destOrd="0" parTransId="{EC5957C7-107A-4186-9DB5-F7CAA6A82FB7}" sibTransId="{76D27C66-90D1-4C9C-B5F7-7B6E11E63743}"/>
    <dgm:cxn modelId="{BB92CCCA-56C7-5442-8272-ACDD5455F5F5}" type="presOf" srcId="{FA488D17-B950-4056-9159-085EDD6A4172}" destId="{02F99878-001D-E642-A469-234F29B3CDB7}" srcOrd="0" destOrd="0" presId="urn:microsoft.com/office/officeart/2005/8/layout/default"/>
    <dgm:cxn modelId="{C03494CC-8E05-48C1-84A0-BF2F0C24DBA7}" srcId="{F5D82D10-4C62-47AC-A661-ADB649EC5146}" destId="{FF14BFD9-900D-41C9-808E-9DA9F74952C5}" srcOrd="3" destOrd="0" parTransId="{1A2A6324-8B10-468D-BB71-5B0B29EA6271}" sibTransId="{0B980722-32F8-4471-8C8C-8519C5EFDEE7}"/>
    <dgm:cxn modelId="{A4F5E0E4-7D75-4076-BE5E-330C48521F98}" srcId="{F5D82D10-4C62-47AC-A661-ADB649EC5146}" destId="{B7C77020-844C-4DD2-93CA-E73EBBF6BDB0}" srcOrd="8" destOrd="0" parTransId="{75FF4A2F-9C8D-4D44-9B24-FD6FF43D6F4B}" sibTransId="{B371589C-ABF3-4FF6-A310-D62FB266A7B6}"/>
    <dgm:cxn modelId="{4BBDF3E6-0EEF-4991-B27C-8CCBA3FFC298}" srcId="{F5D82D10-4C62-47AC-A661-ADB649EC5146}" destId="{FA488D17-B950-4056-9159-085EDD6A4172}" srcOrd="6" destOrd="0" parTransId="{4AEFDE77-35FB-4721-A5B1-11C3475E7AB8}" sibTransId="{FEE98CAB-7AA0-4E84-B694-E122FD89C962}"/>
    <dgm:cxn modelId="{4E3D51EB-53CC-3541-B365-4E5B6E26BDE7}" type="presOf" srcId="{81136B25-FEFA-4BEA-99CD-D8B9C2E36240}" destId="{D4BEB8B4-2AA7-9A4B-A50C-9A3119B8A781}" srcOrd="0" destOrd="0" presId="urn:microsoft.com/office/officeart/2005/8/layout/default"/>
    <dgm:cxn modelId="{615106ED-FA95-430D-8E7A-B3BBD5189D23}" srcId="{F5D82D10-4C62-47AC-A661-ADB649EC5146}" destId="{9F06C56A-AA89-412E-9B23-D48CC3F69F8D}" srcOrd="0" destOrd="0" parTransId="{AE6190F9-A6F6-4861-A922-4B21073A0868}" sibTransId="{788F3F47-FB2E-460B-8B51-F7054BE13484}"/>
    <dgm:cxn modelId="{58B416FA-8B81-435E-BA8A-D2E604DB6839}" srcId="{F5D82D10-4C62-47AC-A661-ADB649EC5146}" destId="{81136B25-FEFA-4BEA-99CD-D8B9C2E36240}" srcOrd="1" destOrd="0" parTransId="{A34F50BE-8708-4DF5-B847-A72139D76844}" sibTransId="{71F05110-D27A-422A-AAB1-203D088468F0}"/>
    <dgm:cxn modelId="{67C1CE50-4053-8E41-BA9F-CD0BE4892D61}" type="presParOf" srcId="{6D1AC633-A897-B440-83C3-E844B7ADA26F}" destId="{12446922-3DAB-404F-A66E-8AE71741814B}" srcOrd="0" destOrd="0" presId="urn:microsoft.com/office/officeart/2005/8/layout/default"/>
    <dgm:cxn modelId="{B81F9E81-8FF1-2E40-880A-31BC42198E5C}" type="presParOf" srcId="{6D1AC633-A897-B440-83C3-E844B7ADA26F}" destId="{80D739DA-91C5-FF41-8DF9-3DC387481839}" srcOrd="1" destOrd="0" presId="urn:microsoft.com/office/officeart/2005/8/layout/default"/>
    <dgm:cxn modelId="{A75CD0BC-8934-BA48-864B-D8728CD4192B}" type="presParOf" srcId="{6D1AC633-A897-B440-83C3-E844B7ADA26F}" destId="{D4BEB8B4-2AA7-9A4B-A50C-9A3119B8A781}" srcOrd="2" destOrd="0" presId="urn:microsoft.com/office/officeart/2005/8/layout/default"/>
    <dgm:cxn modelId="{3571D6CC-B21D-A44B-96B2-A4B4902057C6}" type="presParOf" srcId="{6D1AC633-A897-B440-83C3-E844B7ADA26F}" destId="{C4862B99-D092-4F40-A133-8A67F9946BBD}" srcOrd="3" destOrd="0" presId="urn:microsoft.com/office/officeart/2005/8/layout/default"/>
    <dgm:cxn modelId="{BE3AEC3B-B3D1-5F4F-87D4-608F9C0C1429}" type="presParOf" srcId="{6D1AC633-A897-B440-83C3-E844B7ADA26F}" destId="{2DA6F284-0FD8-384E-ADD7-5C386EE89C8B}" srcOrd="4" destOrd="0" presId="urn:microsoft.com/office/officeart/2005/8/layout/default"/>
    <dgm:cxn modelId="{1DD770BF-F024-854B-9C80-34201A7E03BE}" type="presParOf" srcId="{6D1AC633-A897-B440-83C3-E844B7ADA26F}" destId="{01026B9A-5179-4047-A158-3CC356AB261F}" srcOrd="5" destOrd="0" presId="urn:microsoft.com/office/officeart/2005/8/layout/default"/>
    <dgm:cxn modelId="{A960FBF6-AE2D-0E4F-ADE3-620A0338C009}" type="presParOf" srcId="{6D1AC633-A897-B440-83C3-E844B7ADA26F}" destId="{0AE6701C-D60A-A942-84F6-3612C1CA2CFB}" srcOrd="6" destOrd="0" presId="urn:microsoft.com/office/officeart/2005/8/layout/default"/>
    <dgm:cxn modelId="{E3FB9F13-839E-4746-A613-745BFD7197CB}" type="presParOf" srcId="{6D1AC633-A897-B440-83C3-E844B7ADA26F}" destId="{22071301-CB92-B740-9A70-DE06EE4E3A55}" srcOrd="7" destOrd="0" presId="urn:microsoft.com/office/officeart/2005/8/layout/default"/>
    <dgm:cxn modelId="{807DE916-C52A-F046-9C16-F9596EFE8FD9}" type="presParOf" srcId="{6D1AC633-A897-B440-83C3-E844B7ADA26F}" destId="{3D2F6C50-26A8-1844-A888-42DDBD047B0D}" srcOrd="8" destOrd="0" presId="urn:microsoft.com/office/officeart/2005/8/layout/default"/>
    <dgm:cxn modelId="{D4E1BF4F-FE4C-CA44-BD60-891AB826FD3B}" type="presParOf" srcId="{6D1AC633-A897-B440-83C3-E844B7ADA26F}" destId="{F2436FD0-1902-0941-86D5-CB5DFF2A7197}" srcOrd="9" destOrd="0" presId="urn:microsoft.com/office/officeart/2005/8/layout/default"/>
    <dgm:cxn modelId="{9CB6D74C-EE06-DA45-91E6-E79C730ED3C7}" type="presParOf" srcId="{6D1AC633-A897-B440-83C3-E844B7ADA26F}" destId="{A1F48A39-BE0D-6745-91E2-ADAED66E1054}" srcOrd="10" destOrd="0" presId="urn:microsoft.com/office/officeart/2005/8/layout/default"/>
    <dgm:cxn modelId="{8627596B-F119-9149-A22C-CAF196F16EDE}" type="presParOf" srcId="{6D1AC633-A897-B440-83C3-E844B7ADA26F}" destId="{08ABEC55-87D9-D640-99DA-40B4788B2E65}" srcOrd="11" destOrd="0" presId="urn:microsoft.com/office/officeart/2005/8/layout/default"/>
    <dgm:cxn modelId="{9D0B6A06-B616-4846-A823-AFF07ECA924A}" type="presParOf" srcId="{6D1AC633-A897-B440-83C3-E844B7ADA26F}" destId="{02F99878-001D-E642-A469-234F29B3CDB7}" srcOrd="12" destOrd="0" presId="urn:microsoft.com/office/officeart/2005/8/layout/default"/>
    <dgm:cxn modelId="{32EAD034-73B6-3446-B616-14071233C208}" type="presParOf" srcId="{6D1AC633-A897-B440-83C3-E844B7ADA26F}" destId="{43792A54-9D2B-2744-893B-1584354C0BC0}" srcOrd="13" destOrd="0" presId="urn:microsoft.com/office/officeart/2005/8/layout/default"/>
    <dgm:cxn modelId="{8B518A38-A032-6848-8D71-C686AE1F5DC7}" type="presParOf" srcId="{6D1AC633-A897-B440-83C3-E844B7ADA26F}" destId="{E47F9C0C-2BE2-1F4A-A067-0F215E11967B}" srcOrd="14" destOrd="0" presId="urn:microsoft.com/office/officeart/2005/8/layout/default"/>
    <dgm:cxn modelId="{67D0E2A9-2A99-A744-A824-89D6A84C378C}" type="presParOf" srcId="{6D1AC633-A897-B440-83C3-E844B7ADA26F}" destId="{A6EA4AE6-65E3-334D-A90B-BBF31F9695A6}" srcOrd="15" destOrd="0" presId="urn:microsoft.com/office/officeart/2005/8/layout/default"/>
    <dgm:cxn modelId="{481BE524-D906-314F-9138-5A606825D9A0}" type="presParOf" srcId="{6D1AC633-A897-B440-83C3-E844B7ADA26F}" destId="{FDF79936-D1CC-7E48-93A6-1073F463F0EE}" srcOrd="16" destOrd="0" presId="urn:microsoft.com/office/officeart/2005/8/layout/default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D2DBCB4E-2D68-4515-A208-C091F6BB44B7}" type="doc">
      <dgm:prSet loTypeId="urn:microsoft.com/office/officeart/2005/8/layout/process4" loCatId="process" qsTypeId="urn:microsoft.com/office/officeart/2005/8/quickstyle/simple1" qsCatId="simple" csTypeId="urn:microsoft.com/office/officeart/2005/8/colors/colorful1" csCatId="colorful" phldr="1"/>
      <dgm:spPr/>
      <dgm:t>
        <a:bodyPr/>
        <a:lstStyle/>
        <a:p>
          <a:endParaRPr lang="en-US"/>
        </a:p>
      </dgm:t>
    </dgm:pt>
    <dgm:pt modelId="{1892A359-4FC2-4559-81AA-13F9BE233FD7}">
      <dgm:prSet/>
      <dgm:spPr/>
      <dgm:t>
        <a:bodyPr/>
        <a:lstStyle/>
        <a:p>
          <a:r>
            <a:rPr lang="en-US"/>
            <a:t>Very Good</a:t>
          </a:r>
        </a:p>
      </dgm:t>
    </dgm:pt>
    <dgm:pt modelId="{70EEBA2E-C695-4DDE-BCF6-0775AFA8BFA7}" type="parTrans" cxnId="{300B82AC-0B2D-42E8-BFB1-F6C1624F4141}">
      <dgm:prSet/>
      <dgm:spPr/>
      <dgm:t>
        <a:bodyPr/>
        <a:lstStyle/>
        <a:p>
          <a:endParaRPr lang="en-US"/>
        </a:p>
      </dgm:t>
    </dgm:pt>
    <dgm:pt modelId="{2B059EA6-9C1A-47D3-A843-455D2885C726}" type="sibTrans" cxnId="{300B82AC-0B2D-42E8-BFB1-F6C1624F4141}">
      <dgm:prSet/>
      <dgm:spPr/>
      <dgm:t>
        <a:bodyPr/>
        <a:lstStyle/>
        <a:p>
          <a:endParaRPr lang="en-US"/>
        </a:p>
      </dgm:t>
    </dgm:pt>
    <dgm:pt modelId="{B5B0E80D-4E00-4722-AF69-27535AC57829}">
      <dgm:prSet/>
      <dgm:spPr/>
      <dgm:t>
        <a:bodyPr/>
        <a:lstStyle/>
        <a:p>
          <a:r>
            <a:rPr lang="en-US"/>
            <a:t>With early recognition &amp; diagnosis and antitoxin treatment.</a:t>
          </a:r>
        </a:p>
      </dgm:t>
    </dgm:pt>
    <dgm:pt modelId="{62DCC2BB-6A35-4B3A-80A8-EFB3AFC6E988}" type="parTrans" cxnId="{26E6599C-83B3-4E54-BD45-C3EF8B15B772}">
      <dgm:prSet/>
      <dgm:spPr/>
      <dgm:t>
        <a:bodyPr/>
        <a:lstStyle/>
        <a:p>
          <a:endParaRPr lang="en-US"/>
        </a:p>
      </dgm:t>
    </dgm:pt>
    <dgm:pt modelId="{F184D4DC-8D7C-4E02-AC1D-5DF103702FBD}" type="sibTrans" cxnId="{26E6599C-83B3-4E54-BD45-C3EF8B15B772}">
      <dgm:prSet/>
      <dgm:spPr/>
      <dgm:t>
        <a:bodyPr/>
        <a:lstStyle/>
        <a:p>
          <a:endParaRPr lang="en-US"/>
        </a:p>
      </dgm:t>
    </dgm:pt>
    <dgm:pt modelId="{2230E9B8-2851-4C06-A8CD-039D10D1A3E4}">
      <dgm:prSet/>
      <dgm:spPr/>
      <dgm:t>
        <a:bodyPr/>
        <a:lstStyle/>
        <a:p>
          <a:r>
            <a:rPr lang="en-US"/>
            <a:t>Expected complete recovery within several months to a year.</a:t>
          </a:r>
        </a:p>
      </dgm:t>
    </dgm:pt>
    <dgm:pt modelId="{8F290EC3-ABBB-4048-9B38-ECC8CC1DAF21}" type="parTrans" cxnId="{40A8A9C2-527A-486F-A72E-6050120B2EE1}">
      <dgm:prSet/>
      <dgm:spPr/>
      <dgm:t>
        <a:bodyPr/>
        <a:lstStyle/>
        <a:p>
          <a:endParaRPr lang="en-US"/>
        </a:p>
      </dgm:t>
    </dgm:pt>
    <dgm:pt modelId="{5D47CE7D-0823-427E-8301-FCB388838756}" type="sibTrans" cxnId="{40A8A9C2-527A-486F-A72E-6050120B2EE1}">
      <dgm:prSet/>
      <dgm:spPr/>
      <dgm:t>
        <a:bodyPr/>
        <a:lstStyle/>
        <a:p>
          <a:endParaRPr lang="en-US"/>
        </a:p>
      </dgm:t>
    </dgm:pt>
    <dgm:pt modelId="{10E19EA3-EE30-4287-A5AE-4E5FA90CF1DB}">
      <dgm:prSet/>
      <dgm:spPr/>
      <dgm:t>
        <a:bodyPr/>
        <a:lstStyle/>
        <a:p>
          <a:r>
            <a:rPr lang="en-US" dirty="0"/>
            <a:t>Patients will likely require neurology follow-up and physical therapy as an outpatient upon discharge from the hospital.</a:t>
          </a:r>
        </a:p>
      </dgm:t>
    </dgm:pt>
    <dgm:pt modelId="{6BBE42B1-922D-4572-A1C5-74BA56BB6A5B}" type="parTrans" cxnId="{BEA54487-178F-488C-BAF1-B6C0749A5B8A}">
      <dgm:prSet/>
      <dgm:spPr/>
      <dgm:t>
        <a:bodyPr/>
        <a:lstStyle/>
        <a:p>
          <a:endParaRPr lang="en-US"/>
        </a:p>
      </dgm:t>
    </dgm:pt>
    <dgm:pt modelId="{CE6FAF5A-6E00-4064-A699-3BCFB59CE2BC}" type="sibTrans" cxnId="{BEA54487-178F-488C-BAF1-B6C0749A5B8A}">
      <dgm:prSet/>
      <dgm:spPr/>
      <dgm:t>
        <a:bodyPr/>
        <a:lstStyle/>
        <a:p>
          <a:endParaRPr lang="en-US"/>
        </a:p>
      </dgm:t>
    </dgm:pt>
    <dgm:pt modelId="{7032C050-65F1-4072-8983-4DC65BD22734}">
      <dgm:prSet/>
      <dgm:spPr/>
      <dgm:t>
        <a:bodyPr/>
        <a:lstStyle/>
        <a:p>
          <a:r>
            <a:rPr lang="en-US"/>
            <a:t>Mortality is ~15%</a:t>
          </a:r>
        </a:p>
      </dgm:t>
    </dgm:pt>
    <dgm:pt modelId="{32CF0162-102D-4646-9771-C98D3E955AEB}" type="parTrans" cxnId="{BBDBD040-4C5D-4A28-96D6-5E8CA372146F}">
      <dgm:prSet/>
      <dgm:spPr/>
      <dgm:t>
        <a:bodyPr/>
        <a:lstStyle/>
        <a:p>
          <a:endParaRPr lang="en-US"/>
        </a:p>
      </dgm:t>
    </dgm:pt>
    <dgm:pt modelId="{AB7A512B-8FD4-484C-8AD4-FC47E894EE0E}" type="sibTrans" cxnId="{BBDBD040-4C5D-4A28-96D6-5E8CA372146F}">
      <dgm:prSet/>
      <dgm:spPr/>
      <dgm:t>
        <a:bodyPr/>
        <a:lstStyle/>
        <a:p>
          <a:endParaRPr lang="en-US"/>
        </a:p>
      </dgm:t>
    </dgm:pt>
    <dgm:pt modelId="{9F9C4B5B-8A79-4823-9AFF-5E3D29711E25}">
      <dgm:prSet/>
      <dgm:spPr/>
      <dgm:t>
        <a:bodyPr/>
        <a:lstStyle/>
        <a:p>
          <a:r>
            <a:rPr lang="en-US"/>
            <a:t>Compared to 100 years ago when mortality was 90%.</a:t>
          </a:r>
        </a:p>
      </dgm:t>
    </dgm:pt>
    <dgm:pt modelId="{C281C850-806E-4700-9784-3C9AD0B306E6}" type="parTrans" cxnId="{1225F2EC-DB14-479A-92A2-21C76598AA1C}">
      <dgm:prSet/>
      <dgm:spPr/>
      <dgm:t>
        <a:bodyPr/>
        <a:lstStyle/>
        <a:p>
          <a:endParaRPr lang="en-US"/>
        </a:p>
      </dgm:t>
    </dgm:pt>
    <dgm:pt modelId="{CE31D6DE-5E04-46F2-8CED-27871490452E}" type="sibTrans" cxnId="{1225F2EC-DB14-479A-92A2-21C76598AA1C}">
      <dgm:prSet/>
      <dgm:spPr/>
      <dgm:t>
        <a:bodyPr/>
        <a:lstStyle/>
        <a:p>
          <a:endParaRPr lang="en-US"/>
        </a:p>
      </dgm:t>
    </dgm:pt>
    <dgm:pt modelId="{0CE86D96-86A1-C848-ABF1-70590E809A87}" type="pres">
      <dgm:prSet presAssocID="{D2DBCB4E-2D68-4515-A208-C091F6BB44B7}" presName="Name0" presStyleCnt="0">
        <dgm:presLayoutVars>
          <dgm:dir/>
          <dgm:animLvl val="lvl"/>
          <dgm:resizeHandles val="exact"/>
        </dgm:presLayoutVars>
      </dgm:prSet>
      <dgm:spPr/>
    </dgm:pt>
    <dgm:pt modelId="{AFD0DAE7-4A29-0542-A889-8E5146718AB0}" type="pres">
      <dgm:prSet presAssocID="{7032C050-65F1-4072-8983-4DC65BD22734}" presName="boxAndChildren" presStyleCnt="0"/>
      <dgm:spPr/>
    </dgm:pt>
    <dgm:pt modelId="{0E500350-DFAF-C547-B8EE-511C479ECBBA}" type="pres">
      <dgm:prSet presAssocID="{7032C050-65F1-4072-8983-4DC65BD22734}" presName="parentTextBox" presStyleLbl="node1" presStyleIdx="0" presStyleCnt="3"/>
      <dgm:spPr/>
    </dgm:pt>
    <dgm:pt modelId="{0139AEE0-1534-C943-8448-3A1BA0724C85}" type="pres">
      <dgm:prSet presAssocID="{7032C050-65F1-4072-8983-4DC65BD22734}" presName="entireBox" presStyleLbl="node1" presStyleIdx="0" presStyleCnt="3"/>
      <dgm:spPr/>
    </dgm:pt>
    <dgm:pt modelId="{1BD87A39-AB58-354C-A15A-A8031178AACE}" type="pres">
      <dgm:prSet presAssocID="{7032C050-65F1-4072-8983-4DC65BD22734}" presName="descendantBox" presStyleCnt="0"/>
      <dgm:spPr/>
    </dgm:pt>
    <dgm:pt modelId="{64A0EB94-9A74-704E-B027-4B8727DAE196}" type="pres">
      <dgm:prSet presAssocID="{9F9C4B5B-8A79-4823-9AFF-5E3D29711E25}" presName="childTextBox" presStyleLbl="fgAccFollowNode1" presStyleIdx="0" presStyleCnt="3">
        <dgm:presLayoutVars>
          <dgm:bulletEnabled val="1"/>
        </dgm:presLayoutVars>
      </dgm:prSet>
      <dgm:spPr/>
    </dgm:pt>
    <dgm:pt modelId="{1D2936CC-3BFB-BB46-B224-8EB34F981DF3}" type="pres">
      <dgm:prSet presAssocID="{CE6FAF5A-6E00-4064-A699-3BCFB59CE2BC}" presName="sp" presStyleCnt="0"/>
      <dgm:spPr/>
    </dgm:pt>
    <dgm:pt modelId="{46AFA54C-73DA-9A43-9340-3D5CED6412D1}" type="pres">
      <dgm:prSet presAssocID="{10E19EA3-EE30-4287-A5AE-4E5FA90CF1DB}" presName="arrowAndChildren" presStyleCnt="0"/>
      <dgm:spPr/>
    </dgm:pt>
    <dgm:pt modelId="{A69BF140-F01D-0244-85DC-7624829A4BEC}" type="pres">
      <dgm:prSet presAssocID="{10E19EA3-EE30-4287-A5AE-4E5FA90CF1DB}" presName="parentTextArrow" presStyleLbl="node1" presStyleIdx="1" presStyleCnt="3"/>
      <dgm:spPr/>
    </dgm:pt>
    <dgm:pt modelId="{34DB0439-9A8E-AE47-AA65-56DAF8EDE772}" type="pres">
      <dgm:prSet presAssocID="{2B059EA6-9C1A-47D3-A843-455D2885C726}" presName="sp" presStyleCnt="0"/>
      <dgm:spPr/>
    </dgm:pt>
    <dgm:pt modelId="{5B02E740-A874-9D40-9364-A20714940B85}" type="pres">
      <dgm:prSet presAssocID="{1892A359-4FC2-4559-81AA-13F9BE233FD7}" presName="arrowAndChildren" presStyleCnt="0"/>
      <dgm:spPr/>
    </dgm:pt>
    <dgm:pt modelId="{CB0F3970-DC98-5A4F-8775-13C9A431C920}" type="pres">
      <dgm:prSet presAssocID="{1892A359-4FC2-4559-81AA-13F9BE233FD7}" presName="parentTextArrow" presStyleLbl="node1" presStyleIdx="1" presStyleCnt="3"/>
      <dgm:spPr/>
    </dgm:pt>
    <dgm:pt modelId="{BACB72DF-0667-2F48-88A4-A21DF9A4FE1D}" type="pres">
      <dgm:prSet presAssocID="{1892A359-4FC2-4559-81AA-13F9BE233FD7}" presName="arrow" presStyleLbl="node1" presStyleIdx="2" presStyleCnt="3"/>
      <dgm:spPr/>
    </dgm:pt>
    <dgm:pt modelId="{93D68345-1B26-0341-8FE9-9FC1B664B041}" type="pres">
      <dgm:prSet presAssocID="{1892A359-4FC2-4559-81AA-13F9BE233FD7}" presName="descendantArrow" presStyleCnt="0"/>
      <dgm:spPr/>
    </dgm:pt>
    <dgm:pt modelId="{E076FCB5-D8E2-FD4A-B3DF-E6C07D9F60E4}" type="pres">
      <dgm:prSet presAssocID="{B5B0E80D-4E00-4722-AF69-27535AC57829}" presName="childTextArrow" presStyleLbl="fgAccFollowNode1" presStyleIdx="1" presStyleCnt="3">
        <dgm:presLayoutVars>
          <dgm:bulletEnabled val="1"/>
        </dgm:presLayoutVars>
      </dgm:prSet>
      <dgm:spPr/>
    </dgm:pt>
    <dgm:pt modelId="{E29D92C7-0D56-C048-B61C-54359E730BD4}" type="pres">
      <dgm:prSet presAssocID="{2230E9B8-2851-4C06-A8CD-039D10D1A3E4}" presName="childTextArrow" presStyleLbl="fgAccFollowNode1" presStyleIdx="2" presStyleCnt="3">
        <dgm:presLayoutVars>
          <dgm:bulletEnabled val="1"/>
        </dgm:presLayoutVars>
      </dgm:prSet>
      <dgm:spPr/>
    </dgm:pt>
  </dgm:ptLst>
  <dgm:cxnLst>
    <dgm:cxn modelId="{698EF52B-8913-4C49-9FC9-C7B74CB032C7}" type="presOf" srcId="{1892A359-4FC2-4559-81AA-13F9BE233FD7}" destId="{CB0F3970-DC98-5A4F-8775-13C9A431C920}" srcOrd="0" destOrd="0" presId="urn:microsoft.com/office/officeart/2005/8/layout/process4"/>
    <dgm:cxn modelId="{6EFE8B3C-D8EB-1A4A-8F50-5DEA41AF9E1C}" type="presOf" srcId="{B5B0E80D-4E00-4722-AF69-27535AC57829}" destId="{E076FCB5-D8E2-FD4A-B3DF-E6C07D9F60E4}" srcOrd="0" destOrd="0" presId="urn:microsoft.com/office/officeart/2005/8/layout/process4"/>
    <dgm:cxn modelId="{BBDBD040-4C5D-4A28-96D6-5E8CA372146F}" srcId="{D2DBCB4E-2D68-4515-A208-C091F6BB44B7}" destId="{7032C050-65F1-4072-8983-4DC65BD22734}" srcOrd="2" destOrd="0" parTransId="{32CF0162-102D-4646-9771-C98D3E955AEB}" sibTransId="{AB7A512B-8FD4-484C-8AD4-FC47E894EE0E}"/>
    <dgm:cxn modelId="{64957C47-1014-524F-86C9-3BBB1AC57EC2}" type="presOf" srcId="{D2DBCB4E-2D68-4515-A208-C091F6BB44B7}" destId="{0CE86D96-86A1-C848-ABF1-70590E809A87}" srcOrd="0" destOrd="0" presId="urn:microsoft.com/office/officeart/2005/8/layout/process4"/>
    <dgm:cxn modelId="{E4E74957-9E2B-AB41-B453-3977DAD9D9B0}" type="presOf" srcId="{2230E9B8-2851-4C06-A8CD-039D10D1A3E4}" destId="{E29D92C7-0D56-C048-B61C-54359E730BD4}" srcOrd="0" destOrd="0" presId="urn:microsoft.com/office/officeart/2005/8/layout/process4"/>
    <dgm:cxn modelId="{C41D3A5A-7C03-B745-BD55-3A29596CE547}" type="presOf" srcId="{1892A359-4FC2-4559-81AA-13F9BE233FD7}" destId="{BACB72DF-0667-2F48-88A4-A21DF9A4FE1D}" srcOrd="1" destOrd="0" presId="urn:microsoft.com/office/officeart/2005/8/layout/process4"/>
    <dgm:cxn modelId="{E5140474-6DE0-8D41-A5ED-31945C0FFD12}" type="presOf" srcId="{9F9C4B5B-8A79-4823-9AFF-5E3D29711E25}" destId="{64A0EB94-9A74-704E-B027-4B8727DAE196}" srcOrd="0" destOrd="0" presId="urn:microsoft.com/office/officeart/2005/8/layout/process4"/>
    <dgm:cxn modelId="{BEA54487-178F-488C-BAF1-B6C0749A5B8A}" srcId="{D2DBCB4E-2D68-4515-A208-C091F6BB44B7}" destId="{10E19EA3-EE30-4287-A5AE-4E5FA90CF1DB}" srcOrd="1" destOrd="0" parTransId="{6BBE42B1-922D-4572-A1C5-74BA56BB6A5B}" sibTransId="{CE6FAF5A-6E00-4064-A699-3BCFB59CE2BC}"/>
    <dgm:cxn modelId="{6B368B8A-8021-C842-8DBF-742FBF3C3CD9}" type="presOf" srcId="{10E19EA3-EE30-4287-A5AE-4E5FA90CF1DB}" destId="{A69BF140-F01D-0244-85DC-7624829A4BEC}" srcOrd="0" destOrd="0" presId="urn:microsoft.com/office/officeart/2005/8/layout/process4"/>
    <dgm:cxn modelId="{3FADDB92-CF04-9F49-B442-DE392B7E4D1D}" type="presOf" srcId="{7032C050-65F1-4072-8983-4DC65BD22734}" destId="{0E500350-DFAF-C547-B8EE-511C479ECBBA}" srcOrd="0" destOrd="0" presId="urn:microsoft.com/office/officeart/2005/8/layout/process4"/>
    <dgm:cxn modelId="{26E6599C-83B3-4E54-BD45-C3EF8B15B772}" srcId="{1892A359-4FC2-4559-81AA-13F9BE233FD7}" destId="{B5B0E80D-4E00-4722-AF69-27535AC57829}" srcOrd="0" destOrd="0" parTransId="{62DCC2BB-6A35-4B3A-80A8-EFB3AFC6E988}" sibTransId="{F184D4DC-8D7C-4E02-AC1D-5DF103702FBD}"/>
    <dgm:cxn modelId="{300B82AC-0B2D-42E8-BFB1-F6C1624F4141}" srcId="{D2DBCB4E-2D68-4515-A208-C091F6BB44B7}" destId="{1892A359-4FC2-4559-81AA-13F9BE233FD7}" srcOrd="0" destOrd="0" parTransId="{70EEBA2E-C695-4DDE-BCF6-0775AFA8BFA7}" sibTransId="{2B059EA6-9C1A-47D3-A843-455D2885C726}"/>
    <dgm:cxn modelId="{40A8A9C2-527A-486F-A72E-6050120B2EE1}" srcId="{1892A359-4FC2-4559-81AA-13F9BE233FD7}" destId="{2230E9B8-2851-4C06-A8CD-039D10D1A3E4}" srcOrd="1" destOrd="0" parTransId="{8F290EC3-ABBB-4048-9B38-ECC8CC1DAF21}" sibTransId="{5D47CE7D-0823-427E-8301-FCB388838756}"/>
    <dgm:cxn modelId="{1225F2EC-DB14-479A-92A2-21C76598AA1C}" srcId="{7032C050-65F1-4072-8983-4DC65BD22734}" destId="{9F9C4B5B-8A79-4823-9AFF-5E3D29711E25}" srcOrd="0" destOrd="0" parTransId="{C281C850-806E-4700-9784-3C9AD0B306E6}" sibTransId="{CE31D6DE-5E04-46F2-8CED-27871490452E}"/>
    <dgm:cxn modelId="{CBB2C7FF-5290-AE47-A604-E2BF7592D423}" type="presOf" srcId="{7032C050-65F1-4072-8983-4DC65BD22734}" destId="{0139AEE0-1534-C943-8448-3A1BA0724C85}" srcOrd="1" destOrd="0" presId="urn:microsoft.com/office/officeart/2005/8/layout/process4"/>
    <dgm:cxn modelId="{E3EDDD5C-2660-054D-B011-E18308A5DC38}" type="presParOf" srcId="{0CE86D96-86A1-C848-ABF1-70590E809A87}" destId="{AFD0DAE7-4A29-0542-A889-8E5146718AB0}" srcOrd="0" destOrd="0" presId="urn:microsoft.com/office/officeart/2005/8/layout/process4"/>
    <dgm:cxn modelId="{18CDCE2A-FDD8-2341-8391-99F969A80840}" type="presParOf" srcId="{AFD0DAE7-4A29-0542-A889-8E5146718AB0}" destId="{0E500350-DFAF-C547-B8EE-511C479ECBBA}" srcOrd="0" destOrd="0" presId="urn:microsoft.com/office/officeart/2005/8/layout/process4"/>
    <dgm:cxn modelId="{BFF7ABC5-864D-D143-AB05-E714BA8BC8CB}" type="presParOf" srcId="{AFD0DAE7-4A29-0542-A889-8E5146718AB0}" destId="{0139AEE0-1534-C943-8448-3A1BA0724C85}" srcOrd="1" destOrd="0" presId="urn:microsoft.com/office/officeart/2005/8/layout/process4"/>
    <dgm:cxn modelId="{0C307CD0-4D69-C54E-83CA-9A2081A5EE5B}" type="presParOf" srcId="{AFD0DAE7-4A29-0542-A889-8E5146718AB0}" destId="{1BD87A39-AB58-354C-A15A-A8031178AACE}" srcOrd="2" destOrd="0" presId="urn:microsoft.com/office/officeart/2005/8/layout/process4"/>
    <dgm:cxn modelId="{5D71F43A-F4D7-FD4C-BD14-7AC334717C49}" type="presParOf" srcId="{1BD87A39-AB58-354C-A15A-A8031178AACE}" destId="{64A0EB94-9A74-704E-B027-4B8727DAE196}" srcOrd="0" destOrd="0" presId="urn:microsoft.com/office/officeart/2005/8/layout/process4"/>
    <dgm:cxn modelId="{45E5733A-5F9A-1D4B-861F-33B2A2468A6E}" type="presParOf" srcId="{0CE86D96-86A1-C848-ABF1-70590E809A87}" destId="{1D2936CC-3BFB-BB46-B224-8EB34F981DF3}" srcOrd="1" destOrd="0" presId="urn:microsoft.com/office/officeart/2005/8/layout/process4"/>
    <dgm:cxn modelId="{611E019F-0170-A14F-B7BC-05D2580F3CF5}" type="presParOf" srcId="{0CE86D96-86A1-C848-ABF1-70590E809A87}" destId="{46AFA54C-73DA-9A43-9340-3D5CED6412D1}" srcOrd="2" destOrd="0" presId="urn:microsoft.com/office/officeart/2005/8/layout/process4"/>
    <dgm:cxn modelId="{38E73B74-AEFC-8740-83E5-8E9736239FCE}" type="presParOf" srcId="{46AFA54C-73DA-9A43-9340-3D5CED6412D1}" destId="{A69BF140-F01D-0244-85DC-7624829A4BEC}" srcOrd="0" destOrd="0" presId="urn:microsoft.com/office/officeart/2005/8/layout/process4"/>
    <dgm:cxn modelId="{0243475B-78AF-D14D-A1D1-FFC657AC0F37}" type="presParOf" srcId="{0CE86D96-86A1-C848-ABF1-70590E809A87}" destId="{34DB0439-9A8E-AE47-AA65-56DAF8EDE772}" srcOrd="3" destOrd="0" presId="urn:microsoft.com/office/officeart/2005/8/layout/process4"/>
    <dgm:cxn modelId="{A826B7F7-3D7E-4C45-A7F2-B9A33FB51D1E}" type="presParOf" srcId="{0CE86D96-86A1-C848-ABF1-70590E809A87}" destId="{5B02E740-A874-9D40-9364-A20714940B85}" srcOrd="4" destOrd="0" presId="urn:microsoft.com/office/officeart/2005/8/layout/process4"/>
    <dgm:cxn modelId="{672D0809-E73A-9942-90FF-C64B93D9AD3B}" type="presParOf" srcId="{5B02E740-A874-9D40-9364-A20714940B85}" destId="{CB0F3970-DC98-5A4F-8775-13C9A431C920}" srcOrd="0" destOrd="0" presId="urn:microsoft.com/office/officeart/2005/8/layout/process4"/>
    <dgm:cxn modelId="{CD213F8F-F32D-FE40-ABD4-F7E9B162ED35}" type="presParOf" srcId="{5B02E740-A874-9D40-9364-A20714940B85}" destId="{BACB72DF-0667-2F48-88A4-A21DF9A4FE1D}" srcOrd="1" destOrd="0" presId="urn:microsoft.com/office/officeart/2005/8/layout/process4"/>
    <dgm:cxn modelId="{8298CEF1-FB6B-E745-808E-2095C53A70E6}" type="presParOf" srcId="{5B02E740-A874-9D40-9364-A20714940B85}" destId="{93D68345-1B26-0341-8FE9-9FC1B664B041}" srcOrd="2" destOrd="0" presId="urn:microsoft.com/office/officeart/2005/8/layout/process4"/>
    <dgm:cxn modelId="{530992FC-4A69-7D4B-A271-0D7615E1554C}" type="presParOf" srcId="{93D68345-1B26-0341-8FE9-9FC1B664B041}" destId="{E076FCB5-D8E2-FD4A-B3DF-E6C07D9F60E4}" srcOrd="0" destOrd="0" presId="urn:microsoft.com/office/officeart/2005/8/layout/process4"/>
    <dgm:cxn modelId="{D3FD68CC-E195-F645-8735-D2A5408C7C7F}" type="presParOf" srcId="{93D68345-1B26-0341-8FE9-9FC1B664B041}" destId="{E29D92C7-0D56-C048-B61C-54359E730BD4}" srcOrd="1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2446922-3DAB-404F-A66E-8AE71741814B}">
      <dsp:nvSpPr>
        <dsp:cNvPr id="0" name=""/>
        <dsp:cNvSpPr/>
      </dsp:nvSpPr>
      <dsp:spPr>
        <a:xfrm>
          <a:off x="2578" y="449262"/>
          <a:ext cx="1396045" cy="837627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Congenital myopathy</a:t>
          </a:r>
        </a:p>
      </dsp:txBody>
      <dsp:txXfrm>
        <a:off x="2578" y="449262"/>
        <a:ext cx="1396045" cy="837627"/>
      </dsp:txXfrm>
    </dsp:sp>
    <dsp:sp modelId="{D4BEB8B4-2AA7-9A4B-A50C-9A3119B8A781}">
      <dsp:nvSpPr>
        <dsp:cNvPr id="0" name=""/>
        <dsp:cNvSpPr/>
      </dsp:nvSpPr>
      <dsp:spPr>
        <a:xfrm>
          <a:off x="1538227" y="449262"/>
          <a:ext cx="1396045" cy="837627"/>
        </a:xfrm>
        <a:prstGeom prst="rect">
          <a:avLst/>
        </a:prstGeom>
        <a:solidFill>
          <a:schemeClr val="accent2">
            <a:hueOff val="343292"/>
            <a:satOff val="-6101"/>
            <a:lumOff val="196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Electrolyte imbalance/dehydration (hypoglycemia, hyponatremia, hyperkalemia)</a:t>
          </a:r>
        </a:p>
      </dsp:txBody>
      <dsp:txXfrm>
        <a:off x="1538227" y="449262"/>
        <a:ext cx="1396045" cy="837627"/>
      </dsp:txXfrm>
    </dsp:sp>
    <dsp:sp modelId="{2DA6F284-0FD8-384E-ADD7-5C386EE89C8B}">
      <dsp:nvSpPr>
        <dsp:cNvPr id="0" name=""/>
        <dsp:cNvSpPr/>
      </dsp:nvSpPr>
      <dsp:spPr>
        <a:xfrm>
          <a:off x="3073877" y="449262"/>
          <a:ext cx="1396045" cy="837627"/>
        </a:xfrm>
        <a:prstGeom prst="rect">
          <a:avLst/>
        </a:prstGeom>
        <a:solidFill>
          <a:schemeClr val="accent2">
            <a:hueOff val="686585"/>
            <a:satOff val="-12202"/>
            <a:lumOff val="39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Guillain-Barre syndrome</a:t>
          </a:r>
        </a:p>
      </dsp:txBody>
      <dsp:txXfrm>
        <a:off x="3073877" y="449262"/>
        <a:ext cx="1396045" cy="837627"/>
      </dsp:txXfrm>
    </dsp:sp>
    <dsp:sp modelId="{0AE6701C-D60A-A942-84F6-3612C1CA2CFB}">
      <dsp:nvSpPr>
        <dsp:cNvPr id="0" name=""/>
        <dsp:cNvSpPr/>
      </dsp:nvSpPr>
      <dsp:spPr>
        <a:xfrm>
          <a:off x="4609527" y="449262"/>
          <a:ext cx="1396045" cy="837627"/>
        </a:xfrm>
        <a:prstGeom prst="rect">
          <a:avLst/>
        </a:prstGeom>
        <a:solidFill>
          <a:schemeClr val="accent2">
            <a:hueOff val="1029877"/>
            <a:satOff val="-18303"/>
            <a:lumOff val="58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 dirty="0"/>
            <a:t>Intoxication / Drug Side Effect (ie, Ingestion of sedating medications or marijuana, etc.)</a:t>
          </a:r>
        </a:p>
      </dsp:txBody>
      <dsp:txXfrm>
        <a:off x="4609527" y="449262"/>
        <a:ext cx="1396045" cy="837627"/>
      </dsp:txXfrm>
    </dsp:sp>
    <dsp:sp modelId="{3D2F6C50-26A8-1844-A888-42DDBD047B0D}">
      <dsp:nvSpPr>
        <dsp:cNvPr id="0" name=""/>
        <dsp:cNvSpPr/>
      </dsp:nvSpPr>
      <dsp:spPr>
        <a:xfrm>
          <a:off x="6145176" y="449262"/>
          <a:ext cx="1396045" cy="837627"/>
        </a:xfrm>
        <a:prstGeom prst="rect">
          <a:avLst/>
        </a:prstGeom>
        <a:solidFill>
          <a:schemeClr val="accent2">
            <a:hueOff val="1373170"/>
            <a:satOff val="-24404"/>
            <a:lumOff val="78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Leigh disease</a:t>
          </a:r>
        </a:p>
      </dsp:txBody>
      <dsp:txXfrm>
        <a:off x="6145176" y="449262"/>
        <a:ext cx="1396045" cy="837627"/>
      </dsp:txXfrm>
    </dsp:sp>
    <dsp:sp modelId="{A1F48A39-BE0D-6745-91E2-ADAED66E1054}">
      <dsp:nvSpPr>
        <dsp:cNvPr id="0" name=""/>
        <dsp:cNvSpPr/>
      </dsp:nvSpPr>
      <dsp:spPr>
        <a:xfrm>
          <a:off x="770403" y="1426494"/>
          <a:ext cx="1396045" cy="837627"/>
        </a:xfrm>
        <a:prstGeom prst="rect">
          <a:avLst/>
        </a:prstGeom>
        <a:solidFill>
          <a:schemeClr val="accent2">
            <a:hueOff val="1716462"/>
            <a:satOff val="-30505"/>
            <a:lumOff val="98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Metabolic disorder and encephalopathy</a:t>
          </a:r>
        </a:p>
      </dsp:txBody>
      <dsp:txXfrm>
        <a:off x="770403" y="1426494"/>
        <a:ext cx="1396045" cy="837627"/>
      </dsp:txXfrm>
    </dsp:sp>
    <dsp:sp modelId="{02F99878-001D-E642-A469-234F29B3CDB7}">
      <dsp:nvSpPr>
        <dsp:cNvPr id="0" name=""/>
        <dsp:cNvSpPr/>
      </dsp:nvSpPr>
      <dsp:spPr>
        <a:xfrm>
          <a:off x="2306052" y="1426494"/>
          <a:ext cx="1396045" cy="837627"/>
        </a:xfrm>
        <a:prstGeom prst="rect">
          <a:avLst/>
        </a:prstGeom>
        <a:solidFill>
          <a:schemeClr val="accent2">
            <a:hueOff val="2059755"/>
            <a:satOff val="-36606"/>
            <a:lumOff val="1177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Myasthenia gravis</a:t>
          </a:r>
        </a:p>
      </dsp:txBody>
      <dsp:txXfrm>
        <a:off x="2306052" y="1426494"/>
        <a:ext cx="1396045" cy="837627"/>
      </dsp:txXfrm>
    </dsp:sp>
    <dsp:sp modelId="{E47F9C0C-2BE2-1F4A-A067-0F215E11967B}">
      <dsp:nvSpPr>
        <dsp:cNvPr id="0" name=""/>
        <dsp:cNvSpPr/>
      </dsp:nvSpPr>
      <dsp:spPr>
        <a:xfrm>
          <a:off x="3841702" y="1426494"/>
          <a:ext cx="1396045" cy="837627"/>
        </a:xfrm>
        <a:prstGeom prst="rect">
          <a:avLst/>
        </a:prstGeom>
        <a:solidFill>
          <a:schemeClr val="accent2">
            <a:hueOff val="2403047"/>
            <a:satOff val="-42707"/>
            <a:lumOff val="137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/>
            <a:t>Non-accidental trauma</a:t>
          </a:r>
        </a:p>
      </dsp:txBody>
      <dsp:txXfrm>
        <a:off x="3841702" y="1426494"/>
        <a:ext cx="1396045" cy="837627"/>
      </dsp:txXfrm>
    </dsp:sp>
    <dsp:sp modelId="{FDF79936-D1CC-7E48-93A6-1073F463F0EE}">
      <dsp:nvSpPr>
        <dsp:cNvPr id="0" name=""/>
        <dsp:cNvSpPr/>
      </dsp:nvSpPr>
      <dsp:spPr>
        <a:xfrm>
          <a:off x="5377351" y="1426494"/>
          <a:ext cx="1396045" cy="837627"/>
        </a:xfrm>
        <a:prstGeom prst="rect">
          <a:avLst/>
        </a:prstGeom>
        <a:solidFill>
          <a:schemeClr val="accent2">
            <a:hueOff val="2746340"/>
            <a:satOff val="-48808"/>
            <a:lumOff val="1569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4290" tIns="34290" rIns="34290" bIns="3429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kern="1200" dirty="0"/>
            <a:t>Sepsis (pneumonia, urinary tract infection, meningitis, or other source)</a:t>
          </a:r>
        </a:p>
      </dsp:txBody>
      <dsp:txXfrm>
        <a:off x="5377351" y="1426494"/>
        <a:ext cx="1396045" cy="83762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139AEE0-1534-C943-8448-3A1BA0724C85}">
      <dsp:nvSpPr>
        <dsp:cNvPr id="0" name=""/>
        <dsp:cNvSpPr/>
      </dsp:nvSpPr>
      <dsp:spPr>
        <a:xfrm>
          <a:off x="0" y="2042507"/>
          <a:ext cx="7543800" cy="670396"/>
        </a:xfrm>
        <a:prstGeom prst="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2456" tIns="92456" rIns="92456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Mortality is ~15%</a:t>
          </a:r>
        </a:p>
      </dsp:txBody>
      <dsp:txXfrm>
        <a:off x="0" y="2042507"/>
        <a:ext cx="7543800" cy="362014"/>
      </dsp:txXfrm>
    </dsp:sp>
    <dsp:sp modelId="{64A0EB94-9A74-704E-B027-4B8727DAE196}">
      <dsp:nvSpPr>
        <dsp:cNvPr id="0" name=""/>
        <dsp:cNvSpPr/>
      </dsp:nvSpPr>
      <dsp:spPr>
        <a:xfrm>
          <a:off x="0" y="2391114"/>
          <a:ext cx="7543800" cy="308382"/>
        </a:xfrm>
        <a:prstGeom prst="rect">
          <a:avLst/>
        </a:prstGeom>
        <a:solidFill>
          <a:schemeClr val="accent2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2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1120" tIns="12700" rIns="7112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kern="1200"/>
            <a:t>Compared to 100 years ago when mortality was 90%.</a:t>
          </a:r>
        </a:p>
      </dsp:txBody>
      <dsp:txXfrm>
        <a:off x="0" y="2391114"/>
        <a:ext cx="7543800" cy="308382"/>
      </dsp:txXfrm>
    </dsp:sp>
    <dsp:sp modelId="{A69BF140-F01D-0244-85DC-7624829A4BEC}">
      <dsp:nvSpPr>
        <dsp:cNvPr id="0" name=""/>
        <dsp:cNvSpPr/>
      </dsp:nvSpPr>
      <dsp:spPr>
        <a:xfrm rot="10800000">
          <a:off x="0" y="1021493"/>
          <a:ext cx="7543800" cy="1031070"/>
        </a:xfrm>
        <a:prstGeom prst="upArrowCallout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2456" tIns="92456" rIns="92456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Patients will likely require neurology follow-up and physical therapy as an outpatient upon discharge from the hospital.</a:t>
          </a:r>
        </a:p>
      </dsp:txBody>
      <dsp:txXfrm rot="10800000">
        <a:off x="0" y="1021493"/>
        <a:ext cx="7543800" cy="669958"/>
      </dsp:txXfrm>
    </dsp:sp>
    <dsp:sp modelId="{BACB72DF-0667-2F48-88A4-A21DF9A4FE1D}">
      <dsp:nvSpPr>
        <dsp:cNvPr id="0" name=""/>
        <dsp:cNvSpPr/>
      </dsp:nvSpPr>
      <dsp:spPr>
        <a:xfrm rot="10800000">
          <a:off x="0" y="479"/>
          <a:ext cx="7543800" cy="1031070"/>
        </a:xfrm>
        <a:prstGeom prst="upArrowCallout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2456" tIns="92456" rIns="92456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Very Good</a:t>
          </a:r>
        </a:p>
      </dsp:txBody>
      <dsp:txXfrm rot="-10800000">
        <a:off x="0" y="479"/>
        <a:ext cx="7543800" cy="361905"/>
      </dsp:txXfrm>
    </dsp:sp>
    <dsp:sp modelId="{E076FCB5-D8E2-FD4A-B3DF-E6C07D9F60E4}">
      <dsp:nvSpPr>
        <dsp:cNvPr id="0" name=""/>
        <dsp:cNvSpPr/>
      </dsp:nvSpPr>
      <dsp:spPr>
        <a:xfrm>
          <a:off x="0" y="362385"/>
          <a:ext cx="3771900" cy="308289"/>
        </a:xfrm>
        <a:prstGeom prst="rect">
          <a:avLst/>
        </a:prstGeom>
        <a:solidFill>
          <a:schemeClr val="accent3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1120" tIns="12700" rIns="7112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kern="1200"/>
            <a:t>With early recognition &amp; diagnosis and antitoxin treatment.</a:t>
          </a:r>
        </a:p>
      </dsp:txBody>
      <dsp:txXfrm>
        <a:off x="0" y="362385"/>
        <a:ext cx="3771900" cy="308289"/>
      </dsp:txXfrm>
    </dsp:sp>
    <dsp:sp modelId="{E29D92C7-0D56-C048-B61C-54359E730BD4}">
      <dsp:nvSpPr>
        <dsp:cNvPr id="0" name=""/>
        <dsp:cNvSpPr/>
      </dsp:nvSpPr>
      <dsp:spPr>
        <a:xfrm>
          <a:off x="3771900" y="362385"/>
          <a:ext cx="3771900" cy="308289"/>
        </a:xfrm>
        <a:prstGeom prst="rect">
          <a:avLst/>
        </a:prstGeom>
        <a:solidFill>
          <a:schemeClr val="accent4">
            <a:tint val="40000"/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4">
              <a:tint val="40000"/>
              <a:alpha val="9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71120" tIns="12700" rIns="71120" bIns="1270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000" kern="1200"/>
            <a:t>Expected complete recovery within several months to a year.</a:t>
          </a:r>
        </a:p>
      </dsp:txBody>
      <dsp:txXfrm>
        <a:off x="3771900" y="362385"/>
        <a:ext cx="3771900" cy="30828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default">
  <dgm:title val=""/>
  <dgm:desc val=""/>
  <dgm:catLst>
    <dgm:cat type="list" pri="4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diagram">
    <dgm:varLst>
      <dgm:dir/>
      <dgm:resizeHandles val="exact"/>
    </dgm:varLst>
    <dgm:choose name="Name0">
      <dgm:if name="Name1" func="var" arg="dir" op="equ" val="norm">
        <dgm:alg type="snake">
          <dgm:param type="grDir" val="tL"/>
          <dgm:param type="flowDir" val="row"/>
          <dgm:param type="contDir" val="sameDir"/>
          <dgm:param type="off" val="ctr"/>
        </dgm:alg>
      </dgm:if>
      <dgm:else name="Name2">
        <dgm:alg type="snake">
          <dgm:param type="grDir" val="tR"/>
          <dgm:param type="flowDir" val="row"/>
          <dgm:param type="contDir" val="sameDir"/>
          <dgm:param type="off" val="ct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node" refType="w"/>
      <dgm:constr type="h" for="ch" forName="node" refType="w" refFor="ch" refForName="node" fact="0.6"/>
      <dgm:constr type="w" for="ch" forName="sibTrans" refType="w" refFor="ch" refForName="node" fact="0.1"/>
      <dgm:constr type="sp" refType="w" refFor="ch" refForName="sibTrans"/>
      <dgm:constr type="primFontSz" for="ch" forName="node" op="equ" val="65"/>
    </dgm:constrLst>
    <dgm:ruleLst/>
    <dgm:forEach name="Name3" axis="ch" ptType="node">
      <dgm:layoutNode name="node">
        <dgm:varLst>
          <dgm:bulletEnabled val="1"/>
        </dgm:varLst>
        <dgm:alg type="tx"/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3"/>
          <dgm:constr type="rMarg" refType="primFontSz" fact="0.3"/>
          <dgm:constr type="tMarg" refType="primFontSz" fact="0.3"/>
          <dgm:constr type="bMarg" refType="primFontSz" fact="0.3"/>
        </dgm:constrLst>
        <dgm:ruleLst>
          <dgm:rule type="primFontSz" val="5" fact="NaN" max="NaN"/>
        </dgm:ruleLst>
      </dgm:layoutNode>
      <dgm:forEach name="Name4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: CDC. Clostridium Botulinum. In: Wkimedia Commons. https://commons.wikimedia.org/wiki/File:Clostridium_botulinum.jpg#filelinks. Public Domain.</a:t>
            </a:r>
            <a:endParaRPr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g152e54912cc_0_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6" name="Google Shape;106;g152e54912cc_0_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g15f65af2288_0_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2" name="Google Shape;112;g15f65af2288_0_3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52e54912cc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52e54912cc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: Momofbear. Infant Botulism Patient (own work). In Wkimedia Commons. https://commons.wikimedia.org/wiki/File:Infant_botulism_patient.jpeg. CC-BY-SA-3.0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5f65af2288_0_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5f65af2288_0_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Hege P. Neuromuscular Junction. In Wikimedia Commons. https://commons.wikimedia.org/wiki/File:Neuromuscular_junction.svg. CC BY-SA 4.0 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398592422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52e54912cc_0_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52e54912cc_0_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: CDC/ Dr. V.R. Dowell, Jr. Infant with Botulism File 16681. In: Wkimedia Commons. https://commons.wikimedia.org/wiki/File:16681_lores.jpg. Public Domain.</a:t>
            </a:r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15f65af2288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15f65af2288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: Mis306 at English Wikibooks. Magnifying Glass Photo. In Wikimedia Commons. https://commons.wikimedia.org/wiki/File:Magnifying_Glass_Photo.jpg. Public Domain.</a:t>
            </a: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g152e54912cc_0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2" name="Google Shape;82;g152e54912cc_0_1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g15f65af2288_0_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8" name="Google Shape;88;g15f65af2288_0_2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g152e54912cc_0_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4" name="Google Shape;94;g152e54912cc_0_1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g15f65af2288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0" name="Google Shape;100;g15f65af2288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Layouts/_rels/slideLayout9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Master" Target="../slideMasters/slideMaster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690626" y="1010210"/>
            <a:ext cx="7667244" cy="60512"/>
          </a:xfrm>
          <a:prstGeom prst="rect">
            <a:avLst/>
          </a:prstGeom>
          <a:blipFill dpi="0" rotWithShape="1">
            <a:blip r:embed="rId2">
              <a:alphaModFix amt="83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8" name="Rectangle 7"/>
          <p:cNvSpPr/>
          <p:nvPr/>
        </p:nvSpPr>
        <p:spPr>
          <a:xfrm>
            <a:off x="690626" y="3224773"/>
            <a:ext cx="7667244" cy="60512"/>
          </a:xfrm>
          <a:prstGeom prst="rect">
            <a:avLst/>
          </a:prstGeom>
          <a:blipFill dpi="0" rotWithShape="1">
            <a:blip r:embed="rId2">
              <a:alphaModFix amt="83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9" name="Rectangle 8"/>
          <p:cNvSpPr/>
          <p:nvPr/>
        </p:nvSpPr>
        <p:spPr>
          <a:xfrm>
            <a:off x="690626" y="1113584"/>
            <a:ext cx="7667244" cy="2057400"/>
          </a:xfrm>
          <a:prstGeom prst="rect">
            <a:avLst/>
          </a:prstGeom>
          <a:blipFill dpi="0" rotWithShape="1">
            <a:blip r:embed="rId2">
              <a:alphaModFix amt="83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grpSp>
        <p:nvGrpSpPr>
          <p:cNvPr id="10" name="Group 9"/>
          <p:cNvGrpSpPr/>
          <p:nvPr/>
        </p:nvGrpSpPr>
        <p:grpSpPr>
          <a:xfrm>
            <a:off x="7236911" y="3051692"/>
            <a:ext cx="810678" cy="810677"/>
            <a:chOff x="9685338" y="4460675"/>
            <a:chExt cx="1080904" cy="1080902"/>
          </a:xfrm>
        </p:grpSpPr>
        <p:sp>
          <p:nvSpPr>
            <p:cNvPr id="11" name="Oval 10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5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12" name="Oval 11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8670" y="1074167"/>
            <a:ext cx="7475220" cy="2276856"/>
          </a:xfrm>
        </p:spPr>
        <p:txBody>
          <a:bodyPr anchor="ctr">
            <a:noAutofit/>
          </a:bodyPr>
          <a:lstStyle>
            <a:lvl1pPr algn="l">
              <a:lnSpc>
                <a:spcPct val="85000"/>
              </a:lnSpc>
              <a:defRPr sz="5400" b="1" cap="none" baseline="0">
                <a:blipFill dpi="0" rotWithShape="1">
                  <a:blip r:embed="rId4"/>
                  <a:srcRect/>
                  <a:tile tx="6350" ty="-127000" sx="65000" sy="64000" flip="none" algn="tl"/>
                </a:blip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2386" y="3291840"/>
            <a:ext cx="5918454" cy="802386"/>
          </a:xfrm>
        </p:spPr>
        <p:txBody>
          <a:bodyPr>
            <a:normAutofit/>
          </a:bodyPr>
          <a:lstStyle>
            <a:lvl1pPr marL="0" indent="0" algn="l">
              <a:buNone/>
              <a:defRPr sz="1650">
                <a:solidFill>
                  <a:schemeClr val="tx1"/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pPr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194550" y="3217001"/>
            <a:ext cx="895401" cy="480060"/>
          </a:xfrm>
        </p:spPr>
        <p:txBody>
          <a:bodyPr/>
          <a:lstStyle>
            <a:lvl1pPr>
              <a:defRPr sz="2100" b="1"/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5620102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211202931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400050"/>
            <a:ext cx="1914525" cy="42291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0100" y="400050"/>
            <a:ext cx="5629275" cy="42291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747669580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 and 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175012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747622979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3688492"/>
            <a:ext cx="9144000" cy="1455008"/>
          </a:xfrm>
          <a:prstGeom prst="rect">
            <a:avLst/>
          </a:prstGeom>
          <a:blipFill dpi="0" rotWithShape="1">
            <a:blip r:embed="rId2">
              <a:alphaModFix amt="83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5346" y="918972"/>
            <a:ext cx="6960870" cy="2640330"/>
          </a:xfrm>
        </p:spPr>
        <p:txBody>
          <a:bodyPr anchor="ctr">
            <a:normAutofit/>
          </a:bodyPr>
          <a:lstStyle>
            <a:lvl1pPr>
              <a:lnSpc>
                <a:spcPct val="85000"/>
              </a:lnSpc>
              <a:defRPr sz="54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24331" y="3765042"/>
            <a:ext cx="6789420" cy="800100"/>
          </a:xfrm>
        </p:spPr>
        <p:txBody>
          <a:bodyPr anchor="t">
            <a:normAutofit/>
          </a:bodyPr>
          <a:lstStyle>
            <a:lvl1pPr marL="0" indent="0">
              <a:buNone/>
              <a:defRPr sz="1500">
                <a:solidFill>
                  <a:schemeClr val="tx1"/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6445251" y="4704588"/>
            <a:ext cx="1983232" cy="273844"/>
          </a:xfrm>
        </p:spPr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637031" y="4704588"/>
            <a:ext cx="4745736" cy="273844"/>
          </a:xfrm>
        </p:spPr>
        <p:txBody>
          <a:bodyPr/>
          <a:lstStyle/>
          <a:p>
            <a:endParaRPr lang="en-US" dirty="0"/>
          </a:p>
        </p:txBody>
      </p:sp>
      <p:grpSp>
        <p:nvGrpSpPr>
          <p:cNvPr id="8" name="Group 7"/>
          <p:cNvGrpSpPr/>
          <p:nvPr/>
        </p:nvGrpSpPr>
        <p:grpSpPr>
          <a:xfrm>
            <a:off x="673049" y="1744386"/>
            <a:ext cx="810678" cy="810677"/>
            <a:chOff x="9685338" y="4460675"/>
            <a:chExt cx="1080904" cy="1080902"/>
          </a:xfrm>
        </p:grpSpPr>
        <p:sp>
          <p:nvSpPr>
            <p:cNvPr id="9" name="Oval 8"/>
            <p:cNvSpPr/>
            <p:nvPr/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5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632776" y="1879600"/>
            <a:ext cx="891224" cy="540249"/>
          </a:xfrm>
        </p:spPr>
        <p:txBody>
          <a:bodyPr/>
          <a:lstStyle>
            <a:lvl1pPr>
              <a:defRPr sz="2100"/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750388356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02386" y="1645920"/>
            <a:ext cx="3566160" cy="2983230"/>
          </a:xfrm>
        </p:spPr>
        <p:txBody>
          <a:bodyPr/>
          <a:lstStyle>
            <a:lvl1pPr>
              <a:defRPr sz="1500"/>
            </a:lvl1pPr>
            <a:lvl2pPr>
              <a:defRPr sz="135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73168" y="1645920"/>
            <a:ext cx="3566160" cy="2983230"/>
          </a:xfrm>
        </p:spPr>
        <p:txBody>
          <a:bodyPr/>
          <a:lstStyle>
            <a:lvl1pPr>
              <a:defRPr sz="1500"/>
            </a:lvl1pPr>
            <a:lvl2pPr>
              <a:defRPr sz="135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1578892472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0100" y="1536192"/>
            <a:ext cx="3566160" cy="480060"/>
          </a:xfrm>
        </p:spPr>
        <p:txBody>
          <a:bodyPr anchor="ctr">
            <a:normAutofit/>
          </a:bodyPr>
          <a:lstStyle>
            <a:lvl1pPr marL="0" indent="0">
              <a:buNone/>
              <a:defRPr sz="1500" b="1">
                <a:solidFill>
                  <a:schemeClr val="accent1">
                    <a:lumMod val="7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2386" y="2057400"/>
            <a:ext cx="3566160" cy="2468880"/>
          </a:xfrm>
        </p:spPr>
        <p:txBody>
          <a:bodyPr/>
          <a:lstStyle>
            <a:lvl1pPr>
              <a:defRPr sz="1500"/>
            </a:lvl1pPr>
            <a:lvl2pPr>
              <a:defRPr sz="135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73168" y="1536192"/>
            <a:ext cx="3566160" cy="480060"/>
          </a:xfrm>
        </p:spPr>
        <p:txBody>
          <a:bodyPr anchor="ctr">
            <a:normAutofit/>
          </a:bodyPr>
          <a:lstStyle>
            <a:lvl1pPr marL="0" indent="0">
              <a:buNone/>
              <a:defRPr sz="1500" b="1">
                <a:solidFill>
                  <a:schemeClr val="accent1">
                    <a:lumMod val="7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73168" y="2057400"/>
            <a:ext cx="3566160" cy="2468880"/>
          </a:xfrm>
        </p:spPr>
        <p:txBody>
          <a:bodyPr/>
          <a:lstStyle>
            <a:lvl1pPr>
              <a:defRPr sz="1500"/>
            </a:lvl1pPr>
            <a:lvl2pPr>
              <a:defRPr sz="135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9645810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716640814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906252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6227806" y="1"/>
            <a:ext cx="2916194" cy="51434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2230" y="514350"/>
            <a:ext cx="2400300" cy="1303020"/>
          </a:xfrm>
        </p:spPr>
        <p:txBody>
          <a:bodyPr anchor="b">
            <a:normAutofit/>
          </a:bodyPr>
          <a:lstStyle>
            <a:lvl1pPr>
              <a:defRPr sz="24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8650" y="514350"/>
            <a:ext cx="5033772" cy="3765042"/>
          </a:xfrm>
        </p:spPr>
        <p:txBody>
          <a:bodyPr/>
          <a:lstStyle>
            <a:lvl1pPr>
              <a:defRPr sz="1500"/>
            </a:lvl1pPr>
            <a:lvl2pPr>
              <a:defRPr sz="135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2230" y="1817370"/>
            <a:ext cx="2400300" cy="246888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750"/>
              </a:spcBef>
              <a:buNone/>
              <a:defRPr sz="1050">
                <a:solidFill>
                  <a:schemeClr val="accent1">
                    <a:lumMod val="50000"/>
                  </a:schemeClr>
                </a:solidFill>
              </a:defRPr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grpSp>
        <p:nvGrpSpPr>
          <p:cNvPr id="9" name="Group 8"/>
          <p:cNvGrpSpPr>
            <a:grpSpLocks noChangeAspect="1"/>
          </p:cNvGrpSpPr>
          <p:nvPr/>
        </p:nvGrpSpPr>
        <p:grpSpPr>
          <a:xfrm>
            <a:off x="8551294" y="4672261"/>
            <a:ext cx="342900" cy="342900"/>
            <a:chOff x="11361456" y="6195813"/>
            <a:chExt cx="548640" cy="548640"/>
          </a:xfrm>
        </p:grpSpPr>
        <p:sp>
          <p:nvSpPr>
            <p:cNvPr id="10" name="Oval 9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5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11" name="Oval 10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350377262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6227806" y="1"/>
            <a:ext cx="2916194" cy="5143499"/>
          </a:xfrm>
          <a:prstGeom prst="rect">
            <a:avLst/>
          </a:prstGeom>
          <a:blipFill dpi="0" rotWithShape="1">
            <a:blip r:embed="rId2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2230" y="514350"/>
            <a:ext cx="2400300" cy="1303020"/>
          </a:xfrm>
        </p:spPr>
        <p:txBody>
          <a:bodyPr anchor="b">
            <a:normAutofit/>
          </a:bodyPr>
          <a:lstStyle>
            <a:lvl1pPr>
              <a:defRPr sz="24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6227805" cy="5143500"/>
          </a:xfrm>
          <a:solidFill>
            <a:schemeClr val="tx2">
              <a:lumMod val="20000"/>
              <a:lumOff val="80000"/>
            </a:schemeClr>
          </a:solidFill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2230" y="1817370"/>
            <a:ext cx="2400300" cy="246888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750"/>
              </a:spcBef>
              <a:buNone/>
              <a:defRPr sz="1050">
                <a:solidFill>
                  <a:schemeClr val="accent1">
                    <a:lumMod val="50000"/>
                  </a:schemeClr>
                </a:solidFill>
              </a:defRPr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A87A34-81AB-432B-8DAE-1953F412C126}" type="datetimeFigureOut">
              <a:rPr lang="en-US" smtClean="0"/>
              <a:t>7/22/23</a:t>
            </a:fld>
            <a:endParaRPr lang="en-US" dirty="0"/>
          </a:p>
        </p:txBody>
      </p:sp>
      <p:grpSp>
        <p:nvGrpSpPr>
          <p:cNvPr id="8" name="Group 7"/>
          <p:cNvGrpSpPr>
            <a:grpSpLocks noChangeAspect="1"/>
          </p:cNvGrpSpPr>
          <p:nvPr/>
        </p:nvGrpSpPr>
        <p:grpSpPr>
          <a:xfrm>
            <a:off x="8551294" y="4672261"/>
            <a:ext cx="342900" cy="342900"/>
            <a:chOff x="11361456" y="6195813"/>
            <a:chExt cx="548640" cy="548640"/>
          </a:xfrm>
        </p:grpSpPr>
        <p:sp>
          <p:nvSpPr>
            <p:cNvPr id="9" name="Oval 8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5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10" name="Oval 9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471028999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microsoft.com/office/2007/relationships/hdphoto" Target="../media/hdphoto1.wdp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2386" y="1591056"/>
            <a:ext cx="7543800" cy="30380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73318" y="4704588"/>
            <a:ext cx="2455164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2"/>
                </a:solidFill>
              </a:defRPr>
            </a:lvl1pPr>
          </a:lstStyle>
          <a:p>
            <a:fld id="{48A87A34-81AB-432B-8DAE-1953F412C126}" type="datetimeFigureOut">
              <a:rPr lang="en-US" smtClean="0"/>
              <a:pPr/>
              <a:t>7/22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16102" y="4704588"/>
            <a:ext cx="4745736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grpSp>
        <p:nvGrpSpPr>
          <p:cNvPr id="7" name="Group 6"/>
          <p:cNvGrpSpPr>
            <a:grpSpLocks noChangeAspect="1"/>
          </p:cNvGrpSpPr>
          <p:nvPr/>
        </p:nvGrpSpPr>
        <p:grpSpPr>
          <a:xfrm>
            <a:off x="8551294" y="4672261"/>
            <a:ext cx="342900" cy="342900"/>
            <a:chOff x="11361456" y="6195813"/>
            <a:chExt cx="548640" cy="548640"/>
          </a:xfrm>
        </p:grpSpPr>
        <p:sp>
          <p:nvSpPr>
            <p:cNvPr id="8" name="Oval 7"/>
            <p:cNvSpPr/>
            <p:nvPr/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14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5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9" name="Oval 8"/>
            <p:cNvSpPr/>
            <p:nvPr/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6858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483346" y="4704588"/>
            <a:ext cx="48006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50" b="1">
                <a:solidFill>
                  <a:srgbClr val="FFFFFF"/>
                </a:solidFill>
                <a:latin typeface="+mn-lt"/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445295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9" r:id="rId1"/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600" b="1" kern="1200" cap="none" baseline="0">
          <a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6350" ty="-127000" sx="65000" sy="64000" flip="none" algn="tl"/>
          </a:blipFill>
          <a:latin typeface="+mj-lt"/>
          <a:ea typeface="+mj-ea"/>
          <a:cs typeface="+mj-cs"/>
        </a:defRPr>
      </a:lvl1pPr>
    </p:titleStyle>
    <p:bodyStyle>
      <a:lvl1pPr marL="137160" indent="-137160" algn="l" defTabSz="685800" rtl="0" eaLnBrk="1" latinLnBrk="0" hangingPunct="1">
        <a:lnSpc>
          <a:spcPct val="90000"/>
        </a:lnSpc>
        <a:spcBef>
          <a:spcPts val="900"/>
        </a:spcBef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indent="-13716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indent="-13716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754380" indent="-13716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960120" indent="-13716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1200000" indent="-17145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6pPr>
      <a:lvl7pPr marL="1425000" indent="-17145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7pPr>
      <a:lvl8pPr marL="1650000" indent="-17145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8pPr>
      <a:lvl9pPr marL="1875000" indent="-171450" algn="l" defTabSz="685800" rtl="0" eaLnBrk="1" latinLnBrk="0" hangingPunct="1">
        <a:lnSpc>
          <a:spcPct val="90000"/>
        </a:lnSpc>
        <a:spcBef>
          <a:spcPts val="300"/>
        </a:spcBef>
        <a:spcAft>
          <a:spcPts val="150"/>
        </a:spcAft>
        <a:buClr>
          <a:schemeClr val="accent1">
            <a:lumMod val="75000"/>
          </a:schemeClr>
        </a:buClr>
        <a:buSzPct val="85000"/>
        <a:buFont typeface="Wingdings" pitchFamily="2" charset="2"/>
        <a:buChar char="§"/>
        <a:defRPr sz="1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5.jpeg"/><Relationship Id="rId4" Type="http://schemas.microsoft.com/office/2007/relationships/hdphoto" Target="../media/hdphoto2.wdp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image" Target="../media/image2.png"/><Relationship Id="rId7" Type="http://schemas.openxmlformats.org/officeDocument/2006/relationships/diagramData" Target="../diagrams/data2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11" Type="http://schemas.microsoft.com/office/2007/relationships/diagramDrawing" Target="../diagrams/drawing2.xml"/><Relationship Id="rId5" Type="http://schemas.openxmlformats.org/officeDocument/2006/relationships/image" Target="../media/image4.png"/><Relationship Id="rId10" Type="http://schemas.openxmlformats.org/officeDocument/2006/relationships/diagramColors" Target="../diagrams/colors2.xml"/><Relationship Id="rId4" Type="http://schemas.microsoft.com/office/2007/relationships/hdphoto" Target="../media/hdphoto1.wdp"/><Relationship Id="rId9" Type="http://schemas.openxmlformats.org/officeDocument/2006/relationships/diagramQuickStyle" Target="../diagrams/quickStyle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7.jpeg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9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10.jpeg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3.wdp"/><Relationship Id="rId5" Type="http://schemas.openxmlformats.org/officeDocument/2006/relationships/image" Target="../media/image11.png"/><Relationship Id="rId4" Type="http://schemas.microsoft.com/office/2007/relationships/hdphoto" Target="../media/hdphoto1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1.xml"/><Relationship Id="rId3" Type="http://schemas.openxmlformats.org/officeDocument/2006/relationships/image" Target="../media/image2.png"/><Relationship Id="rId7" Type="http://schemas.openxmlformats.org/officeDocument/2006/relationships/diagramData" Target="../diagrams/data1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11" Type="http://schemas.microsoft.com/office/2007/relationships/diagramDrawing" Target="../diagrams/drawing1.xml"/><Relationship Id="rId5" Type="http://schemas.openxmlformats.org/officeDocument/2006/relationships/image" Target="../media/image4.png"/><Relationship Id="rId10" Type="http://schemas.openxmlformats.org/officeDocument/2006/relationships/diagramColors" Target="../diagrams/colors1.xml"/><Relationship Id="rId4" Type="http://schemas.microsoft.com/office/2007/relationships/hdphoto" Target="../media/hdphoto1.wdp"/><Relationship Id="rId9" Type="http://schemas.openxmlformats.org/officeDocument/2006/relationships/diagramQuickStyle" Target="../diagrams/quickStyle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2.xml"/><Relationship Id="rId6" Type="http://schemas.microsoft.com/office/2007/relationships/hdphoto" Target="../media/hdphoto2.wdp"/><Relationship Id="rId5" Type="http://schemas.openxmlformats.org/officeDocument/2006/relationships/image" Target="../media/image4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1" name="Rectangle 1070">
            <a:extLst>
              <a:ext uri="{FF2B5EF4-FFF2-40B4-BE49-F238E27FC236}">
                <a16:creationId xmlns:a16="http://schemas.microsoft.com/office/drawing/2014/main" id="{D8E837CA-4F14-488E-B978-C16C9A19A4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0" y="0"/>
            <a:ext cx="9141714" cy="5143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1073" name="Rectangle 1072">
            <a:extLst>
              <a:ext uri="{FF2B5EF4-FFF2-40B4-BE49-F238E27FC236}">
                <a16:creationId xmlns:a16="http://schemas.microsoft.com/office/drawing/2014/main" id="{A31D588E-4BEB-459D-8053-B9363722D7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90625" y="696087"/>
            <a:ext cx="7763256" cy="60513"/>
          </a:xfrm>
          <a:prstGeom prst="rect">
            <a:avLst/>
          </a:prstGeom>
          <a:blipFill dpi="0" rotWithShape="1">
            <a:blip r:embed="rId3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5" name="Rectangle 1074">
            <a:extLst>
              <a:ext uri="{FF2B5EF4-FFF2-40B4-BE49-F238E27FC236}">
                <a16:creationId xmlns:a16="http://schemas.microsoft.com/office/drawing/2014/main" id="{4E9E1286-F76F-4EB4-9B6A-520847AD718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90624" y="832539"/>
            <a:ext cx="4973574" cy="3435226"/>
          </a:xfrm>
          <a:prstGeom prst="rect">
            <a:avLst/>
          </a:prstGeom>
          <a:blipFill dpi="0" rotWithShape="1">
            <a:blip r:embed="rId3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936117" y="1074167"/>
            <a:ext cx="4474102" cy="2518482"/>
          </a:xfrm>
          <a:prstGeom prst="rect">
            <a:avLst/>
          </a:prstGeom>
        </p:spPr>
        <p:txBody>
          <a:bodyPr spcFirstLastPara="1" lIns="91425" tIns="91425" rIns="91425" bIns="91425" anchor="ctr" anchorCtr="0">
            <a:norm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000"/>
              <a:t>Infant Botulism</a:t>
            </a:r>
            <a:endParaRPr lang="en-US" sz="6000" dirty="0"/>
          </a:p>
        </p:txBody>
      </p:sp>
      <p:sp>
        <p:nvSpPr>
          <p:cNvPr id="55" name="Google Shape;55;p13"/>
          <p:cNvSpPr txBox="1">
            <a:spLocks noGrp="1"/>
          </p:cNvSpPr>
          <p:nvPr>
            <p:ph type="subTitle" idx="1"/>
          </p:nvPr>
        </p:nvSpPr>
        <p:spPr>
          <a:xfrm>
            <a:off x="936117" y="3592649"/>
            <a:ext cx="4474102" cy="501577"/>
          </a:xfrm>
          <a:prstGeom prst="rect">
            <a:avLst/>
          </a:prstGeom>
        </p:spPr>
        <p:txBody>
          <a:bodyPr spcFirstLastPara="1" lIns="91425" tIns="91425" rIns="91425" bIns="91425" anchorCtr="0">
            <a:normAutofit/>
          </a:bodyPr>
          <a:lstStyle/>
          <a:p>
            <a:pPr marL="0" lvl="0" indent="0" rtl="0">
              <a:spcBef>
                <a:spcPts val="0"/>
              </a:spcBef>
              <a:spcAft>
                <a:spcPts val="600"/>
              </a:spcAft>
              <a:buNone/>
            </a:pPr>
            <a:r>
              <a:rPr lang="en-US" sz="1500"/>
              <a:t>Oral Boards Case</a:t>
            </a:r>
          </a:p>
        </p:txBody>
      </p:sp>
      <p:pic>
        <p:nvPicPr>
          <p:cNvPr id="1026" name="Picture 2" descr="A close-up of a circle&#10;&#10;Description automatically generated with low confidence">
            <a:extLst>
              <a:ext uri="{FF2B5EF4-FFF2-40B4-BE49-F238E27FC236}">
                <a16:creationId xmlns:a16="http://schemas.microsoft.com/office/drawing/2014/main" id="{A85F9D4A-3429-BD11-CE3C-CE577E36776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57" t="6926" r="10407" b="5801"/>
          <a:stretch/>
        </p:blipFill>
        <p:spPr bwMode="auto">
          <a:xfrm>
            <a:off x="5891337" y="1240600"/>
            <a:ext cx="2562544" cy="26343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77" name="Rectangle 1076">
            <a:extLst>
              <a:ext uri="{FF2B5EF4-FFF2-40B4-BE49-F238E27FC236}">
                <a16:creationId xmlns:a16="http://schemas.microsoft.com/office/drawing/2014/main" id="{F3E8B4EC-3D07-4306-9FAD-448704062CC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90625" y="4335423"/>
            <a:ext cx="7763256" cy="60513"/>
          </a:xfrm>
          <a:prstGeom prst="rect">
            <a:avLst/>
          </a:prstGeom>
          <a:blipFill dpi="0" rotWithShape="1">
            <a:blip r:embed="rId3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79" name="Group 1078">
            <a:extLst>
              <a:ext uri="{FF2B5EF4-FFF2-40B4-BE49-F238E27FC236}">
                <a16:creationId xmlns:a16="http://schemas.microsoft.com/office/drawing/2014/main" id="{25167E2D-A7EB-43A4-86B3-5819BEB87D6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7235190" y="3943350"/>
            <a:ext cx="810678" cy="810676"/>
            <a:chOff x="9685338" y="4460675"/>
            <a:chExt cx="1080904" cy="1080902"/>
          </a:xfrm>
        </p:grpSpPr>
        <p:sp>
          <p:nvSpPr>
            <p:cNvPr id="1080" name="Oval 1079">
              <a:extLst>
                <a:ext uri="{FF2B5EF4-FFF2-40B4-BE49-F238E27FC236}">
                  <a16:creationId xmlns:a16="http://schemas.microsoft.com/office/drawing/2014/main" id="{B2293BB0-EC57-4AD0-85D2-AFCF2778950F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9685338" y="4460675"/>
              <a:ext cx="1080904" cy="1080902"/>
            </a:xfrm>
            <a:prstGeom prst="ellipse">
              <a:avLst/>
            </a:prstGeom>
            <a:blipFill dpi="0" rotWithShape="1">
              <a:blip r:embed="rId6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1081" name="Oval 1080">
              <a:extLst>
                <a:ext uri="{FF2B5EF4-FFF2-40B4-BE49-F238E27FC236}">
                  <a16:creationId xmlns:a16="http://schemas.microsoft.com/office/drawing/2014/main" id="{D0BFBAFA-3D50-45DB-A784-0112BD8E88E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9793429" y="4568765"/>
              <a:ext cx="864723" cy="86472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pic>
        <p:nvPicPr>
          <p:cNvPr id="2" name="Picture 8">
            <a:extLst>
              <a:ext uri="{FF2B5EF4-FFF2-40B4-BE49-F238E27FC236}">
                <a16:creationId xmlns:a16="http://schemas.microsoft.com/office/drawing/2014/main" id="{6C8D0060-37E7-FDBA-503A-8F137B17D52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40529" y="4623403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Group 114">
            <a:extLst>
              <a:ext uri="{FF2B5EF4-FFF2-40B4-BE49-F238E27FC236}">
                <a16:creationId xmlns:a16="http://schemas.microsoft.com/office/drawing/2014/main" id="{766238F3-962C-47EF-BBD1-CFC421D3B8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116" name="Oval 115">
              <a:extLst>
                <a:ext uri="{FF2B5EF4-FFF2-40B4-BE49-F238E27FC236}">
                  <a16:creationId xmlns:a16="http://schemas.microsoft.com/office/drawing/2014/main" id="{15043D81-4F99-4570-96A8-0A787D43C2F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B115D4A1-FA42-4067-AACD-B5134F3C71E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108" name="Google Shape;108;p22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4800"/>
              <a:t>Prognosis</a:t>
            </a:r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3DFE545D-86C5-4F48-897C-C3AA8FBE3DE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0100" y="1509969"/>
            <a:ext cx="7543800" cy="60513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11" name="Google Shape;109;p22">
            <a:extLst>
              <a:ext uri="{FF2B5EF4-FFF2-40B4-BE49-F238E27FC236}">
                <a16:creationId xmlns:a16="http://schemas.microsoft.com/office/drawing/2014/main" id="{ADC6CD83-89DC-A1A9-3F47-4F79B4479C4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84546973"/>
              </p:ext>
            </p:extLst>
          </p:nvPr>
        </p:nvGraphicFramePr>
        <p:xfrm>
          <a:off x="802481" y="1789042"/>
          <a:ext cx="7543800" cy="271338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" name="Group 119">
            <a:extLst>
              <a:ext uri="{FF2B5EF4-FFF2-40B4-BE49-F238E27FC236}">
                <a16:creationId xmlns:a16="http://schemas.microsoft.com/office/drawing/2014/main" id="{132FD491-28F3-42E7-AEBF-A9E3C462C9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121" name="Oval 120">
              <a:extLst>
                <a:ext uri="{FF2B5EF4-FFF2-40B4-BE49-F238E27FC236}">
                  <a16:creationId xmlns:a16="http://schemas.microsoft.com/office/drawing/2014/main" id="{AD016B6E-F283-4CFB-9099-05C8DA6AB3F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22" name="Oval 121">
              <a:extLst>
                <a:ext uri="{FF2B5EF4-FFF2-40B4-BE49-F238E27FC236}">
                  <a16:creationId xmlns:a16="http://schemas.microsoft.com/office/drawing/2014/main" id="{72D0360E-345F-4790-B0A0-03ADC36B5E4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 useBgFill="1">
        <p:nvSpPr>
          <p:cNvPr id="124" name="Rectangle 123">
            <a:extLst>
              <a:ext uri="{FF2B5EF4-FFF2-40B4-BE49-F238E27FC236}">
                <a16:creationId xmlns:a16="http://schemas.microsoft.com/office/drawing/2014/main" id="{E009DD9B-5EE2-4C0D-8B2B-351C8C1022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4000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E720DB99-7745-4E75-9D96-AAB6D55C531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348089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28" name="Rectangle 127">
            <a:extLst>
              <a:ext uri="{FF2B5EF4-FFF2-40B4-BE49-F238E27FC236}">
                <a16:creationId xmlns:a16="http://schemas.microsoft.com/office/drawing/2014/main" id="{D68803C4-E159-4360-B7BB-74205C8F78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451464"/>
            <a:ext cx="7667244" cy="1039405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504B0465-3B07-49BF-BEA7-D8147624629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1528991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4" name="Google Shape;114;p23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5400" cap="all"/>
              <a:t>References:</a:t>
            </a:r>
          </a:p>
        </p:txBody>
      </p:sp>
      <p:sp>
        <p:nvSpPr>
          <p:cNvPr id="115" name="Google Shape;115;p23"/>
          <p:cNvSpPr txBox="1">
            <a:spLocks noGrp="1"/>
          </p:cNvSpPr>
          <p:nvPr>
            <p:ph type="body" idx="1"/>
          </p:nvPr>
        </p:nvSpPr>
        <p:spPr>
          <a:xfrm>
            <a:off x="802386" y="1740309"/>
            <a:ext cx="7543800" cy="2888840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rmAutofit fontScale="92500"/>
          </a:bodyPr>
          <a:lstStyle/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Department of Public Health.</a:t>
            </a:r>
            <a:r>
              <a:rPr lang="en-US" sz="800" i="1" dirty="0"/>
              <a:t> Welcome to the Infant Botulism Treatment and Prevention Program</a:t>
            </a:r>
            <a:r>
              <a:rPr lang="en-US" sz="800" dirty="0"/>
              <a:t>, 2010.  At: https://www.infantbotulism.org/general/babybig.php.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Griese SE, Kisselburgh HM, Bartenfeld MT, et al. Pediatric botulism and use of equine botulinum antitoxin in children: a systematic review. </a:t>
            </a:r>
            <a:r>
              <a:rPr lang="en-US" sz="800" i="1" dirty="0"/>
              <a:t>Clin Infect Dis. </a:t>
            </a:r>
            <a:r>
              <a:rPr lang="en-US" sz="800" dirty="0"/>
              <a:t>2017 Dec 27;66(suppl_1):S17-S29.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Lyons-Warren AM, Risen SR, Clark G. Infant botulism with asymmetric cranial nerve palsies. </a:t>
            </a:r>
            <a:r>
              <a:rPr lang="en-US" sz="800" i="1" dirty="0"/>
              <a:t>Pediatr Neu</a:t>
            </a:r>
            <a:r>
              <a:rPr lang="en-US" sz="800" dirty="0"/>
              <a:t>r</a:t>
            </a:r>
            <a:r>
              <a:rPr lang="en-US" sz="800" i="1" dirty="0"/>
              <a:t>ol</a:t>
            </a:r>
            <a:r>
              <a:rPr lang="en-US" sz="800" dirty="0"/>
              <a:t>. 2019 Mar;92:71-72. 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Kuehn B. Wound Botulism Outbreak. </a:t>
            </a:r>
            <a:r>
              <a:rPr lang="en-US" sz="800" i="1" dirty="0"/>
              <a:t>JAMA</a:t>
            </a:r>
            <a:r>
              <a:rPr lang="en-US" sz="800" dirty="0"/>
              <a:t>. 2019 Feb 12;321(6):538. 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Ni SA, Brady MF. StatPearls [Internet]. StatPearls Publishing; Treasure Island (FL): Apr 8, 2022. Botulism Antitoxin.  At: https://www.ncbi.nlm.nih.gov/books/NBK534807/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Sobel J, Rao AK. Making the best of the evidence: toward national clinical guidelines for botulism. </a:t>
            </a:r>
            <a:r>
              <a:rPr lang="en-US" sz="800" i="1" dirty="0"/>
              <a:t>Clin Infect Dis</a:t>
            </a:r>
            <a:r>
              <a:rPr lang="en-US" sz="800" dirty="0"/>
              <a:t>. 2017 Dec 27;66(suppl_1):S1-S3. </a:t>
            </a:r>
          </a:p>
          <a:p>
            <a:pPr marL="0" indent="-182880" defTabSz="914400">
              <a:lnSpc>
                <a:spcPct val="100000"/>
              </a:lnSpc>
              <a:spcBef>
                <a:spcPts val="1200"/>
              </a:spcBef>
              <a:buSzPct val="85000"/>
              <a:buFont typeface="Wingdings" pitchFamily="2" charset="2"/>
              <a:buChar char="§"/>
            </a:pPr>
            <a:r>
              <a:rPr lang="en-US" sz="800" dirty="0"/>
              <a:t>Van Horn NL, Street M. Infantile Botulism. [Updated 2022 Jun 21]. In: StatPearls [Internet]. Treasure Island (FL): StatPearls Publishing; 2022 Jan-. Available from:    https://www.ncbi.nlm.nih.gov/books/NBK493178/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Walsh K. Case reports on dangerous infectious diseases: a review of patient consent. </a:t>
            </a:r>
            <a:r>
              <a:rPr lang="en-US" sz="800" i="1" dirty="0"/>
              <a:t>BMJ Mil Health</a:t>
            </a:r>
            <a:r>
              <a:rPr lang="en-US" sz="800" dirty="0"/>
              <a:t>. 2020 Jun;166(3):179-180.</a:t>
            </a:r>
          </a:p>
          <a:p>
            <a:pPr marL="0" lvl="0" indent="-182880" defTabSz="914400">
              <a:spcBef>
                <a:spcPts val="1200"/>
              </a:spcBef>
              <a:spcAft>
                <a:spcPts val="1200"/>
              </a:spcAft>
              <a:buSzPct val="85000"/>
              <a:buFont typeface="Wingdings" pitchFamily="2" charset="2"/>
              <a:buChar char="§"/>
            </a:pPr>
            <a:r>
              <a:rPr lang="en-US" sz="800" dirty="0"/>
              <a:t>Wendt S, Eder I, Wölfel R, Braun P, Lippmann N, Rodloff A. Botulism: diagnosis and therapy. </a:t>
            </a:r>
            <a:r>
              <a:rPr lang="en-US" sz="800" i="1" dirty="0"/>
              <a:t>Dtsch Med Wochenschr</a:t>
            </a:r>
            <a:r>
              <a:rPr lang="en-US" sz="800" dirty="0"/>
              <a:t>. 2017 Sep;142(17):1304-1312. </a:t>
            </a:r>
          </a:p>
        </p:txBody>
      </p:sp>
      <p:sp>
        <p:nvSpPr>
          <p:cNvPr id="132" name="Oval 131">
            <a:extLst>
              <a:ext uri="{FF2B5EF4-FFF2-40B4-BE49-F238E27FC236}">
                <a16:creationId xmlns:a16="http://schemas.microsoft.com/office/drawing/2014/main" id="{49B7FFA5-14CB-4A4F-9BCC-CA3AA5D9D27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51293" y="4672260"/>
            <a:ext cx="342900" cy="342900"/>
          </a:xfrm>
          <a:prstGeom prst="ellipse">
            <a:avLst/>
          </a:prstGeom>
          <a:blipFill dpi="0" rotWithShape="1">
            <a:blip r:embed="rId3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rcRect/>
            <a:tile tx="50800" ty="0" sx="85000" sy="85000" flip="none" algn="tl"/>
          </a:blipFill>
          <a:ln w="25400" cap="flat" cmpd="sng" algn="ctr">
            <a:noFill/>
            <a:prstDash val="solid"/>
          </a:ln>
          <a:effectLst/>
        </p:spPr>
        <p:txBody>
          <a:bodyPr lIns="0" tIns="0" rIns="0" bIns="0"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0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Rockwell Extra Bold" pitchFamily="18" charset="0"/>
              <a:ea typeface="+mn-ea"/>
              <a:cs typeface="+mn-cs"/>
            </a:endParaRPr>
          </a:p>
        </p:txBody>
      </p:sp>
      <p:sp>
        <p:nvSpPr>
          <p:cNvPr id="134" name="Oval 133">
            <a:extLst>
              <a:ext uri="{FF2B5EF4-FFF2-40B4-BE49-F238E27FC236}">
                <a16:creationId xmlns:a16="http://schemas.microsoft.com/office/drawing/2014/main" id="{04E48745-7512-4EC2-9E20-9092D12150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73188" y="4694155"/>
            <a:ext cx="299110" cy="299111"/>
          </a:xfrm>
          <a:prstGeom prst="ellipse">
            <a:avLst/>
          </a:prstGeom>
          <a:noFill/>
          <a:ln w="12700" cap="flat" cmpd="sng" algn="ctr">
            <a:solidFill>
              <a:srgbClr val="FFFFFF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65" name="Group 2054">
            <a:extLst>
              <a:ext uri="{FF2B5EF4-FFF2-40B4-BE49-F238E27FC236}">
                <a16:creationId xmlns:a16="http://schemas.microsoft.com/office/drawing/2014/main" id="{E54E1BC5-9799-4C37-9E39-75AD94AE070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2056" name="Oval 2055">
              <a:extLst>
                <a:ext uri="{FF2B5EF4-FFF2-40B4-BE49-F238E27FC236}">
                  <a16:creationId xmlns:a16="http://schemas.microsoft.com/office/drawing/2014/main" id="{6EC783E0-E2C4-43D2-93E5-38337F8DADB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2057" name="Oval 2056">
              <a:extLst>
                <a:ext uri="{FF2B5EF4-FFF2-40B4-BE49-F238E27FC236}">
                  <a16:creationId xmlns:a16="http://schemas.microsoft.com/office/drawing/2014/main" id="{542544D0-650E-4448-A7E2-E5C6D739848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2066" name="Rectangle 2058">
            <a:extLst>
              <a:ext uri="{FF2B5EF4-FFF2-40B4-BE49-F238E27FC236}">
                <a16:creationId xmlns:a16="http://schemas.microsoft.com/office/drawing/2014/main" id="{06A34260-5B8F-475C-82B7-2D4257A02C8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549876" y="0"/>
            <a:ext cx="4594123" cy="5143499"/>
          </a:xfrm>
          <a:prstGeom prst="rect">
            <a:avLst/>
          </a:prstGeom>
          <a:blipFill dpi="0" rotWithShape="1">
            <a:blip r:embed="rId5">
              <a:alphaModFix amt="60000"/>
              <a:lum bright="70000" contrast="-7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Google Shape;60;p14"/>
          <p:cNvSpPr txBox="1">
            <a:spLocks noGrp="1"/>
          </p:cNvSpPr>
          <p:nvPr>
            <p:ph type="title"/>
          </p:nvPr>
        </p:nvSpPr>
        <p:spPr>
          <a:xfrm>
            <a:off x="4800600" y="363474"/>
            <a:ext cx="3974689" cy="1207008"/>
          </a:xfrm>
          <a:prstGeom prst="rect">
            <a:avLst/>
          </a:prstGeom>
          <a:ln>
            <a:noFill/>
          </a:ln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3000" dirty="0"/>
              <a:t>Infant Botulism - An Overview</a:t>
            </a:r>
          </a:p>
        </p:txBody>
      </p:sp>
      <p:sp>
        <p:nvSpPr>
          <p:cNvPr id="61" name="Google Shape;61;p14"/>
          <p:cNvSpPr txBox="1">
            <a:spLocks noGrp="1"/>
          </p:cNvSpPr>
          <p:nvPr>
            <p:ph type="body" idx="1"/>
          </p:nvPr>
        </p:nvSpPr>
        <p:spPr>
          <a:xfrm>
            <a:off x="4800599" y="1591056"/>
            <a:ext cx="3974689" cy="3038094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rmAutofit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b="1" dirty="0">
                <a:solidFill>
                  <a:srgbClr val="0070C0"/>
                </a:solidFill>
              </a:rPr>
              <a:t>Infant botulism </a:t>
            </a:r>
            <a:r>
              <a:rPr lang="en-US" sz="1100" dirty="0"/>
              <a:t>occurs in pediatric patients </a:t>
            </a:r>
            <a:r>
              <a:rPr lang="en-US" sz="1100" b="1" dirty="0">
                <a:solidFill>
                  <a:srgbClr val="0070C0"/>
                </a:solidFill>
              </a:rPr>
              <a:t>less than 1 year of age</a:t>
            </a:r>
            <a:r>
              <a:rPr lang="en-US" sz="1100" dirty="0">
                <a:solidFill>
                  <a:srgbClr val="0070C0"/>
                </a:solidFill>
              </a:rPr>
              <a:t> </a:t>
            </a:r>
            <a:r>
              <a:rPr lang="en-US" sz="1100" dirty="0"/>
              <a:t>and is the most common presentation of all botulism infection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b="1" dirty="0">
                <a:solidFill>
                  <a:srgbClr val="0070C0"/>
                </a:solidFill>
              </a:rPr>
              <a:t>70% of all new botulism cases </a:t>
            </a:r>
            <a:r>
              <a:rPr lang="en-US" sz="1100" dirty="0"/>
              <a:t>fall into this category annually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dirty="0"/>
              <a:t>There are </a:t>
            </a:r>
            <a:r>
              <a:rPr lang="en-US" sz="1100" b="1" dirty="0">
                <a:solidFill>
                  <a:srgbClr val="0070C0"/>
                </a:solidFill>
              </a:rPr>
              <a:t>~100 reported cases </a:t>
            </a:r>
            <a:r>
              <a:rPr lang="en-US" sz="1100" dirty="0"/>
              <a:t>in the United States each year, with the majority of cases occurring in </a:t>
            </a:r>
            <a:r>
              <a:rPr lang="en-US" sz="1100" b="1" dirty="0">
                <a:solidFill>
                  <a:srgbClr val="0070C0"/>
                </a:solidFill>
              </a:rPr>
              <a:t>California.</a:t>
            </a:r>
            <a:r>
              <a:rPr lang="en-US" sz="1100" dirty="0">
                <a:solidFill>
                  <a:srgbClr val="0070C0"/>
                </a:solidFill>
              </a:rPr>
              <a:t> 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b="1" dirty="0">
                <a:solidFill>
                  <a:srgbClr val="0070C0"/>
                </a:solidFill>
              </a:rPr>
              <a:t>20% of cases </a:t>
            </a:r>
            <a:r>
              <a:rPr lang="en-US" sz="1100" dirty="0"/>
              <a:t>are thought to be due to </a:t>
            </a:r>
            <a:r>
              <a:rPr lang="en-US" sz="1100" b="1" dirty="0">
                <a:solidFill>
                  <a:srgbClr val="0070C0"/>
                </a:solidFill>
              </a:rPr>
              <a:t>spore exposure in honey</a:t>
            </a:r>
            <a:r>
              <a:rPr lang="en-US" sz="1100" dirty="0"/>
              <a:t>, but in the majority of cases the source of spores is unknown.  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b="1" u="sng" dirty="0"/>
              <a:t>Risk factors include</a:t>
            </a:r>
            <a:r>
              <a:rPr lang="en-US" sz="1100" dirty="0"/>
              <a:t>: higher birth weights, infants of mothers of advanced maternal age, and breastfed infant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100" b="1" u="sng" dirty="0"/>
              <a:t>Incidence is higher</a:t>
            </a:r>
            <a:r>
              <a:rPr lang="en-US" sz="1100" dirty="0"/>
              <a:t>: in immigrant families of Asian and Hispanic descent.</a:t>
            </a:r>
          </a:p>
        </p:txBody>
      </p:sp>
      <p:grpSp>
        <p:nvGrpSpPr>
          <p:cNvPr id="2067" name="Group 2060">
            <a:extLst>
              <a:ext uri="{FF2B5EF4-FFF2-40B4-BE49-F238E27FC236}">
                <a16:creationId xmlns:a16="http://schemas.microsoft.com/office/drawing/2014/main" id="{A27DB3B6-A2D5-48D2-A788-91160F4792A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2068" name="Oval 2061">
              <a:extLst>
                <a:ext uri="{FF2B5EF4-FFF2-40B4-BE49-F238E27FC236}">
                  <a16:creationId xmlns:a16="http://schemas.microsoft.com/office/drawing/2014/main" id="{1417360B-59C7-4B4B-90F5-168C7076E82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2069" name="Oval 2062">
              <a:extLst>
                <a:ext uri="{FF2B5EF4-FFF2-40B4-BE49-F238E27FC236}">
                  <a16:creationId xmlns:a16="http://schemas.microsoft.com/office/drawing/2014/main" id="{84401733-5996-467C-9FAB-20D38417F8AE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pic>
        <p:nvPicPr>
          <p:cNvPr id="3076" name="Picture 4">
            <a:extLst>
              <a:ext uri="{FF2B5EF4-FFF2-40B4-BE49-F238E27FC236}">
                <a16:creationId xmlns:a16="http://schemas.microsoft.com/office/drawing/2014/main" id="{986F0ADC-F8DF-64FB-21B8-418D94D65FD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064" y="111284"/>
            <a:ext cx="3388399" cy="45178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B1A5C9-0854-25FE-0738-BB57D29B730F}"/>
              </a:ext>
            </a:extLst>
          </p:cNvPr>
          <p:cNvSpPr txBox="1"/>
          <p:nvPr/>
        </p:nvSpPr>
        <p:spPr>
          <a:xfrm>
            <a:off x="217712" y="4618530"/>
            <a:ext cx="438820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his is a child with diagnosed infant botulism. He is unable to move or open his eyes. His cry is barely audible. He is awake and not sedated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88" name="Group 3087">
            <a:extLst>
              <a:ext uri="{FF2B5EF4-FFF2-40B4-BE49-F238E27FC236}">
                <a16:creationId xmlns:a16="http://schemas.microsoft.com/office/drawing/2014/main" id="{C2470417-D0DB-4EF9-B24D-533252BDD39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3089" name="Oval 3088">
              <a:extLst>
                <a:ext uri="{FF2B5EF4-FFF2-40B4-BE49-F238E27FC236}">
                  <a16:creationId xmlns:a16="http://schemas.microsoft.com/office/drawing/2014/main" id="{5DD43A5E-96FC-4417-AAAA-6D22205AE73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3090" name="Oval 3089">
              <a:extLst>
                <a:ext uri="{FF2B5EF4-FFF2-40B4-BE49-F238E27FC236}">
                  <a16:creationId xmlns:a16="http://schemas.microsoft.com/office/drawing/2014/main" id="{AC8EC610-CBFB-4415-82B2-94F68101CF9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3092" name="Rectangle 3091">
            <a:extLst>
              <a:ext uri="{FF2B5EF4-FFF2-40B4-BE49-F238E27FC236}">
                <a16:creationId xmlns:a16="http://schemas.microsoft.com/office/drawing/2014/main" id="{47F26634-9FA8-4679-B619-B9DFA21E0D1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877232" y="0"/>
            <a:ext cx="3266767" cy="5143499"/>
          </a:xfrm>
          <a:prstGeom prst="rect">
            <a:avLst/>
          </a:prstGeom>
          <a:blipFill dpi="0" rotWithShape="1">
            <a:blip r:embed="rId5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Google Shape;66;p15"/>
          <p:cNvSpPr txBox="1">
            <a:spLocks noGrp="1"/>
          </p:cNvSpPr>
          <p:nvPr>
            <p:ph type="title"/>
          </p:nvPr>
        </p:nvSpPr>
        <p:spPr>
          <a:xfrm>
            <a:off x="6140456" y="150235"/>
            <a:ext cx="2658026" cy="811854"/>
          </a:xfrm>
          <a:prstGeom prst="rect">
            <a:avLst/>
          </a:prstGeom>
          <a:ln>
            <a:noFill/>
          </a:ln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2200" dirty="0"/>
              <a:t>Pathophysiology</a:t>
            </a:r>
          </a:p>
        </p:txBody>
      </p:sp>
      <p:sp>
        <p:nvSpPr>
          <p:cNvPr id="67" name="Google Shape;67;p15"/>
          <p:cNvSpPr txBox="1">
            <a:spLocks noGrp="1"/>
          </p:cNvSpPr>
          <p:nvPr>
            <p:ph type="body" idx="1"/>
          </p:nvPr>
        </p:nvSpPr>
        <p:spPr>
          <a:xfrm>
            <a:off x="5877233" y="867301"/>
            <a:ext cx="3184472" cy="3783064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Autofit/>
          </a:bodyPr>
          <a:lstStyle/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b="1" dirty="0">
                <a:solidFill>
                  <a:srgbClr val="0070C0"/>
                </a:solidFill>
              </a:rPr>
              <a:t>Clostridium botulinum </a:t>
            </a:r>
            <a:r>
              <a:rPr lang="en-US" sz="1200" dirty="0"/>
              <a:t>is an </a:t>
            </a:r>
            <a:r>
              <a:rPr lang="en-US" sz="1200" b="1" dirty="0">
                <a:solidFill>
                  <a:srgbClr val="0070C0"/>
                </a:solidFill>
              </a:rPr>
              <a:t>anaerobic spore-forming, gram-positive bacillus.</a:t>
            </a:r>
          </a:p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After inactive spores are ingested, they </a:t>
            </a:r>
            <a:r>
              <a:rPr lang="en-US" sz="1200" b="1" dirty="0">
                <a:solidFill>
                  <a:srgbClr val="0070C0"/>
                </a:solidFill>
              </a:rPr>
              <a:t>germinate in the infant’s immature gastrointestinal tract</a:t>
            </a:r>
            <a:r>
              <a:rPr lang="en-US" sz="1200" dirty="0"/>
              <a:t>.</a:t>
            </a:r>
          </a:p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The spores ultimately produce a </a:t>
            </a:r>
            <a:r>
              <a:rPr lang="en-US" sz="1200" b="1" dirty="0">
                <a:solidFill>
                  <a:srgbClr val="0070C0"/>
                </a:solidFill>
              </a:rPr>
              <a:t>neurotoxin</a:t>
            </a:r>
            <a:r>
              <a:rPr lang="en-US" sz="1200" dirty="0"/>
              <a:t> that </a:t>
            </a:r>
            <a:r>
              <a:rPr lang="en-US" sz="1200" b="1" dirty="0">
                <a:solidFill>
                  <a:srgbClr val="0070C0"/>
                </a:solidFill>
              </a:rPr>
              <a:t>prevents the release of acetylcholine (Ach) at the presynapse </a:t>
            </a:r>
            <a:r>
              <a:rPr lang="en-US" sz="1200" dirty="0"/>
              <a:t>causing flaccid paralysis.</a:t>
            </a:r>
          </a:p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Typically, the neurotoxin affects first the bulbar musculature followed by the somatic musculature </a:t>
            </a:r>
            <a:r>
              <a:rPr lang="en-US" sz="1200" b="1" dirty="0">
                <a:solidFill>
                  <a:srgbClr val="0070C0"/>
                </a:solidFill>
              </a:rPr>
              <a:t>(descending paralysis). </a:t>
            </a:r>
          </a:p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After spores are ingested by infants, there is </a:t>
            </a:r>
            <a:r>
              <a:rPr lang="en-US" sz="1200" b="1" dirty="0">
                <a:solidFill>
                  <a:srgbClr val="0070C0"/>
                </a:solidFill>
              </a:rPr>
              <a:t>10-30 days incubation period</a:t>
            </a:r>
            <a:r>
              <a:rPr lang="en-US" sz="1200" dirty="0"/>
              <a:t> before the onset of symptoms.</a:t>
            </a:r>
          </a:p>
          <a:p>
            <a:pPr marL="457200" marR="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Infants most commonly present </a:t>
            </a:r>
            <a:r>
              <a:rPr lang="en-US" sz="1200" b="1" dirty="0">
                <a:solidFill>
                  <a:srgbClr val="0070C0"/>
                </a:solidFill>
              </a:rPr>
              <a:t>at 3-4 months of age. </a:t>
            </a:r>
          </a:p>
        </p:txBody>
      </p:sp>
      <p:grpSp>
        <p:nvGrpSpPr>
          <p:cNvPr id="3094" name="Group 3093">
            <a:extLst>
              <a:ext uri="{FF2B5EF4-FFF2-40B4-BE49-F238E27FC236}">
                <a16:creationId xmlns:a16="http://schemas.microsoft.com/office/drawing/2014/main" id="{79456847-F660-4ED4-9541-E8AB51FCAF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3095" name="Oval 3094">
              <a:extLst>
                <a:ext uri="{FF2B5EF4-FFF2-40B4-BE49-F238E27FC236}">
                  <a16:creationId xmlns:a16="http://schemas.microsoft.com/office/drawing/2014/main" id="{CBA548B4-3D52-4409-99DD-B2A24D201508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3096" name="Oval 3095">
              <a:extLst>
                <a:ext uri="{FF2B5EF4-FFF2-40B4-BE49-F238E27FC236}">
                  <a16:creationId xmlns:a16="http://schemas.microsoft.com/office/drawing/2014/main" id="{3AE84337-22C7-4E22-AAE5-97E3848BCE09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pic>
        <p:nvPicPr>
          <p:cNvPr id="4098" name="Picture 2">
            <a:extLst>
              <a:ext uri="{FF2B5EF4-FFF2-40B4-BE49-F238E27FC236}">
                <a16:creationId xmlns:a16="http://schemas.microsoft.com/office/drawing/2014/main" id="{B30FBE52-438B-A99E-46AC-A27B4740FE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056" y="1513413"/>
            <a:ext cx="3536184" cy="3158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86586F3-2B5B-487F-9E47-82FF85DAB08E}"/>
              </a:ext>
            </a:extLst>
          </p:cNvPr>
          <p:cNvSpPr txBox="1"/>
          <p:nvPr/>
        </p:nvSpPr>
        <p:spPr>
          <a:xfrm>
            <a:off x="3871917" y="1846341"/>
            <a:ext cx="1852637" cy="244682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+mj-lt"/>
              </a:rPr>
              <a:t>The Effects of Botulinum Neurotoxin (BoNT)</a:t>
            </a:r>
          </a:p>
          <a:p>
            <a:pPr algn="ctr"/>
            <a:endParaRPr lang="en-US" sz="1200" b="1" dirty="0">
              <a:latin typeface="+mj-lt"/>
            </a:endParaRPr>
          </a:p>
          <a:p>
            <a:pPr algn="ctr"/>
            <a:r>
              <a:rPr lang="en-US" sz="1150" dirty="0">
                <a:latin typeface="+mj-lt"/>
              </a:rPr>
              <a:t>BoNT prevents Ach synaptic vesicles from fusing with the presynaptic membrane. Downstream effects lead to muscle paralysis.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83117CA-55BC-EA45-BD06-EE8247BB524F}"/>
              </a:ext>
            </a:extLst>
          </p:cNvPr>
          <p:cNvSpPr txBox="1"/>
          <p:nvPr/>
        </p:nvSpPr>
        <p:spPr>
          <a:xfrm>
            <a:off x="183055" y="77618"/>
            <a:ext cx="3536185" cy="1538883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+mj-lt"/>
              </a:rPr>
              <a:t>Normal Neuromuscular Transmission</a:t>
            </a:r>
          </a:p>
          <a:p>
            <a:pPr algn="ctr"/>
            <a:endParaRPr lang="en-US" sz="1000" b="1" dirty="0">
              <a:latin typeface="+mj-lt"/>
            </a:endParaRPr>
          </a:p>
          <a:p>
            <a:pPr algn="ctr"/>
            <a:r>
              <a:rPr lang="en-US" sz="1150" dirty="0">
                <a:latin typeface="+mj-lt"/>
              </a:rPr>
              <a:t>Synaptic vesicles containing ACh fuse with the presynaptic membrane causing Ach to be released. Binding with the postsynaptic Ach receptor leads to muscle contraction.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50BDB333-8D67-649C-E824-87568B98729D}"/>
              </a:ext>
            </a:extLst>
          </p:cNvPr>
          <p:cNvCxnSpPr>
            <a:cxnSpLocks/>
          </p:cNvCxnSpPr>
          <p:nvPr/>
        </p:nvCxnSpPr>
        <p:spPr>
          <a:xfrm flipH="1">
            <a:off x="2336800" y="2954788"/>
            <a:ext cx="1535117" cy="138048"/>
          </a:xfrm>
          <a:prstGeom prst="line">
            <a:avLst/>
          </a:prstGeom>
          <a:ln w="476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2C24EF09-DA6A-84AD-E314-C42071DEDAE2}"/>
              </a:ext>
            </a:extLst>
          </p:cNvPr>
          <p:cNvSpPr txBox="1"/>
          <p:nvPr/>
        </p:nvSpPr>
        <p:spPr>
          <a:xfrm>
            <a:off x="2093244" y="2954788"/>
            <a:ext cx="322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3206591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07" name="Group 4106">
            <a:extLst>
              <a:ext uri="{FF2B5EF4-FFF2-40B4-BE49-F238E27FC236}">
                <a16:creationId xmlns:a16="http://schemas.microsoft.com/office/drawing/2014/main" id="{D53EB867-02A0-4F33-BAD2-5AD3C989106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4108" name="Oval 4107">
              <a:extLst>
                <a:ext uri="{FF2B5EF4-FFF2-40B4-BE49-F238E27FC236}">
                  <a16:creationId xmlns:a16="http://schemas.microsoft.com/office/drawing/2014/main" id="{ACC1BC2C-52FF-4777-8BD1-4EDB1F74270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4109" name="Oval 4108">
              <a:extLst>
                <a:ext uri="{FF2B5EF4-FFF2-40B4-BE49-F238E27FC236}">
                  <a16:creationId xmlns:a16="http://schemas.microsoft.com/office/drawing/2014/main" id="{9D11487F-7D0C-423B-BDF9-FD7EE21D65F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4111" name="Rectangle 4110">
            <a:extLst>
              <a:ext uri="{FF2B5EF4-FFF2-40B4-BE49-F238E27FC236}">
                <a16:creationId xmlns:a16="http://schemas.microsoft.com/office/drawing/2014/main" id="{3C70C9C1-4C26-457E-A529-B8091CAC170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487552" y="0"/>
            <a:ext cx="5656448" cy="5143499"/>
          </a:xfrm>
          <a:prstGeom prst="rect">
            <a:avLst/>
          </a:prstGeom>
          <a:blipFill dpi="0" rotWithShape="1">
            <a:blip r:embed="rId5">
              <a:alphaModFix amt="60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Google Shape;72;p16"/>
          <p:cNvSpPr txBox="1">
            <a:spLocks noGrp="1"/>
          </p:cNvSpPr>
          <p:nvPr>
            <p:ph type="title"/>
          </p:nvPr>
        </p:nvSpPr>
        <p:spPr>
          <a:xfrm>
            <a:off x="3727581" y="363474"/>
            <a:ext cx="5047708" cy="713233"/>
          </a:xfrm>
          <a:prstGeom prst="rect">
            <a:avLst/>
          </a:prstGeom>
          <a:ln>
            <a:noFill/>
          </a:ln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dirty="0"/>
              <a:t>Presentation</a:t>
            </a:r>
          </a:p>
        </p:txBody>
      </p:sp>
      <p:sp>
        <p:nvSpPr>
          <p:cNvPr id="73" name="Google Shape;73;p16"/>
          <p:cNvSpPr txBox="1">
            <a:spLocks noGrp="1"/>
          </p:cNvSpPr>
          <p:nvPr>
            <p:ph type="body" idx="1"/>
          </p:nvPr>
        </p:nvSpPr>
        <p:spPr>
          <a:xfrm>
            <a:off x="3727581" y="1076707"/>
            <a:ext cx="5047707" cy="3916558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Autofit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Initial symptoms typically involve the gastrointestinal tract such as nausea, vomiting, and diarrhea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These symptoms progress into </a:t>
            </a:r>
            <a:r>
              <a:rPr lang="en-US" sz="1200" b="1" dirty="0">
                <a:solidFill>
                  <a:srgbClr val="0070C0"/>
                </a:solidFill>
              </a:rPr>
              <a:t>poor feeding, lethargy, and constipation</a:t>
            </a:r>
            <a:r>
              <a:rPr lang="en-US" sz="1200" dirty="0">
                <a:solidFill>
                  <a:srgbClr val="0070C0"/>
                </a:solidFill>
              </a:rPr>
              <a:t>.</a:t>
            </a:r>
            <a:r>
              <a:rPr lang="en-US" sz="1200" dirty="0"/>
              <a:t>  Parents may also describe a </a:t>
            </a:r>
            <a:r>
              <a:rPr lang="en-US" sz="1200" b="1" dirty="0">
                <a:solidFill>
                  <a:srgbClr val="0070C0"/>
                </a:solidFill>
              </a:rPr>
              <a:t>“weak cry.”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b="1" dirty="0">
                <a:solidFill>
                  <a:srgbClr val="0070C0"/>
                </a:solidFill>
              </a:rPr>
              <a:t>Bulbar symptoms in the infant: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Ptosis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Dilated with sluggish pupil response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Excessive drooling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Weak suckle reflex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Diminished gag reflex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Shallow and slowed breathing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b="1" dirty="0">
                <a:solidFill>
                  <a:srgbClr val="0070C0"/>
                </a:solidFill>
              </a:rPr>
              <a:t>Somatic symptoms in the infant: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“Floppy” extremities and poor muscular tone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Decreased anal sphincter tone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dirty="0"/>
              <a:t>Diminished deep tendon reflexes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200" b="1" dirty="0">
                <a:solidFill>
                  <a:srgbClr val="0070C0"/>
                </a:solidFill>
              </a:rPr>
              <a:t>Mentation is generally preserved.</a:t>
            </a:r>
          </a:p>
        </p:txBody>
      </p:sp>
      <p:grpSp>
        <p:nvGrpSpPr>
          <p:cNvPr id="4113" name="Group 4112">
            <a:extLst>
              <a:ext uri="{FF2B5EF4-FFF2-40B4-BE49-F238E27FC236}">
                <a16:creationId xmlns:a16="http://schemas.microsoft.com/office/drawing/2014/main" id="{099FE2EA-9E5E-4C8E-A341-C1D5842A205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4114" name="Oval 4113">
              <a:extLst>
                <a:ext uri="{FF2B5EF4-FFF2-40B4-BE49-F238E27FC236}">
                  <a16:creationId xmlns:a16="http://schemas.microsoft.com/office/drawing/2014/main" id="{D6974EC8-68EF-4705-928A-14A203F251F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4115" name="Oval 4114">
              <a:extLst>
                <a:ext uri="{FF2B5EF4-FFF2-40B4-BE49-F238E27FC236}">
                  <a16:creationId xmlns:a16="http://schemas.microsoft.com/office/drawing/2014/main" id="{6F8E3E59-4600-4A0E-AFE3-8B8CC1D27BF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pic>
        <p:nvPicPr>
          <p:cNvPr id="2052" name="Picture 4">
            <a:extLst>
              <a:ext uri="{FF2B5EF4-FFF2-40B4-BE49-F238E27FC236}">
                <a16:creationId xmlns:a16="http://schemas.microsoft.com/office/drawing/2014/main" id="{C40EFEF8-C771-66E3-E438-B2E18484FD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683" y="160975"/>
            <a:ext cx="3174186" cy="48215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7" name="Group 5126">
            <a:extLst>
              <a:ext uri="{FF2B5EF4-FFF2-40B4-BE49-F238E27FC236}">
                <a16:creationId xmlns:a16="http://schemas.microsoft.com/office/drawing/2014/main" id="{E54E1BC5-9799-4C37-9E39-75AD94AE070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5128" name="Oval 5127">
              <a:extLst>
                <a:ext uri="{FF2B5EF4-FFF2-40B4-BE49-F238E27FC236}">
                  <a16:creationId xmlns:a16="http://schemas.microsoft.com/office/drawing/2014/main" id="{6EC783E0-E2C4-43D2-93E5-38337F8DADB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5129" name="Oval 5128">
              <a:extLst>
                <a:ext uri="{FF2B5EF4-FFF2-40B4-BE49-F238E27FC236}">
                  <a16:creationId xmlns:a16="http://schemas.microsoft.com/office/drawing/2014/main" id="{542544D0-650E-4448-A7E2-E5C6D739848A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78" name="Google Shape;78;p17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4800"/>
              <a:t>Clues to the diagnosis!</a:t>
            </a:r>
          </a:p>
        </p:txBody>
      </p:sp>
      <p:sp>
        <p:nvSpPr>
          <p:cNvPr id="79" name="Google Shape;79;p17"/>
          <p:cNvSpPr txBox="1">
            <a:spLocks noGrp="1"/>
          </p:cNvSpPr>
          <p:nvPr>
            <p:ph type="body" idx="1"/>
          </p:nvPr>
        </p:nvSpPr>
        <p:spPr>
          <a:xfrm>
            <a:off x="802386" y="1591056"/>
            <a:ext cx="3569589" cy="3038094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rmAutofit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Hypotonia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Constipation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Weak sucking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Hoarse crying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Symmetrical descending weakness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/>
              <a:t>Breastfeeding mothers may note breast engorgement due to poor feeding.</a:t>
            </a:r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F451693D-FE0E-8F76-222F-5FA4770CC66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9766" y="1591056"/>
            <a:ext cx="3392977" cy="2534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0" name="Group 89">
            <a:extLst>
              <a:ext uri="{FF2B5EF4-FFF2-40B4-BE49-F238E27FC236}">
                <a16:creationId xmlns:a16="http://schemas.microsoft.com/office/drawing/2014/main" id="{132FD491-28F3-42E7-AEBF-A9E3C462C9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99" name="Oval 90">
              <a:extLst>
                <a:ext uri="{FF2B5EF4-FFF2-40B4-BE49-F238E27FC236}">
                  <a16:creationId xmlns:a16="http://schemas.microsoft.com/office/drawing/2014/main" id="{AD016B6E-F283-4CFB-9099-05C8DA6AB3F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92" name="Oval 91">
              <a:extLst>
                <a:ext uri="{FF2B5EF4-FFF2-40B4-BE49-F238E27FC236}">
                  <a16:creationId xmlns:a16="http://schemas.microsoft.com/office/drawing/2014/main" id="{72D0360E-345F-4790-B0A0-03ADC36B5E4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 useBgFill="1">
        <p:nvSpPr>
          <p:cNvPr id="94" name="Rectangle 93">
            <a:extLst>
              <a:ext uri="{FF2B5EF4-FFF2-40B4-BE49-F238E27FC236}">
                <a16:creationId xmlns:a16="http://schemas.microsoft.com/office/drawing/2014/main" id="{5118BA95-03E7-41B7-B442-0AF8C0A7FF6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2286" y="0"/>
            <a:ext cx="9141714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grpSp>
        <p:nvGrpSpPr>
          <p:cNvPr id="96" name="Group 95">
            <a:extLst>
              <a:ext uri="{FF2B5EF4-FFF2-40B4-BE49-F238E27FC236}">
                <a16:creationId xmlns:a16="http://schemas.microsoft.com/office/drawing/2014/main" id="{E799C3D5-7D55-4046-808C-F290F456D6E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795776" y="1259676"/>
            <a:ext cx="2624148" cy="2624144"/>
            <a:chOff x="1061035" y="1679569"/>
            <a:chExt cx="3498864" cy="3498858"/>
          </a:xfrm>
        </p:grpSpPr>
        <p:sp>
          <p:nvSpPr>
            <p:cNvPr id="97" name="Oval 96">
              <a:extLst>
                <a:ext uri="{FF2B5EF4-FFF2-40B4-BE49-F238E27FC236}">
                  <a16:creationId xmlns:a16="http://schemas.microsoft.com/office/drawing/2014/main" id="{059D8741-EAD6-41B1-A882-70D70FC35821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061035" y="1679569"/>
              <a:ext cx="3498864" cy="3498858"/>
            </a:xfrm>
            <a:prstGeom prst="ellipse">
              <a:avLst/>
            </a:prstGeom>
            <a:blipFill dpi="0" rotWithShape="1">
              <a:blip r:embed="rId5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400000"/>
                        </a14:imgEffect>
                        <a14:imgEffect>
                          <a14:brightnessContrast bright="-40000" contrast="40000"/>
                        </a14:imgEffect>
                      </a14:imgLayer>
                    </a14:imgProps>
                  </a:ext>
                </a:extLst>
              </a:blip>
              <a:srcRect/>
              <a:tile tx="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  <p:txBody>
            <a:bodyPr lIns="0" tIns="0" rIns="0" bIns="0"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20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Rockwell Extra Bold" pitchFamily="18" charset="0"/>
                <a:ea typeface="+mn-ea"/>
                <a:cs typeface="+mn-cs"/>
              </a:endParaRPr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45444F36-3103-4D11-A25F-C054D4606DA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246134" y="1864667"/>
              <a:ext cx="3128666" cy="3128662"/>
            </a:xfrm>
            <a:prstGeom prst="ellipse">
              <a:avLst/>
            </a:prstGeom>
            <a:noFill/>
            <a:ln w="25400" cap="flat" cmpd="sng" algn="ctr">
              <a:solidFill>
                <a:sysClr val="window" lastClr="FFFFFF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84" name="Google Shape;84;p18"/>
          <p:cNvSpPr txBox="1">
            <a:spLocks noGrp="1"/>
          </p:cNvSpPr>
          <p:nvPr>
            <p:ph type="title"/>
          </p:nvPr>
        </p:nvSpPr>
        <p:spPr>
          <a:xfrm>
            <a:off x="1117608" y="1782646"/>
            <a:ext cx="1980485" cy="1578205"/>
          </a:xfrm>
          <a:prstGeom prst="rect">
            <a:avLst/>
          </a:prstGeom>
          <a:noFill/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algn="ctr" defTabSz="914400">
              <a:spcBef>
                <a:spcPct val="0"/>
              </a:spcBef>
              <a:spcAft>
                <a:spcPts val="0"/>
              </a:spcAft>
            </a:pPr>
            <a:r>
              <a:rPr lang="en-US" sz="1800" cap="all">
                <a:solidFill>
                  <a:srgbClr val="FFFFFF"/>
                </a:solidFill>
              </a:rPr>
              <a:t>Evaluation</a:t>
            </a:r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AD9B3EAD-A2B3-42C4-927C-3455E3E69EE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>
            <a:off x="2626708" y="2541494"/>
            <a:ext cx="2743200" cy="60512"/>
          </a:xfrm>
          <a:prstGeom prst="rect">
            <a:avLst/>
          </a:prstGeom>
          <a:blipFill dpi="0" rotWithShape="1">
            <a:blip r:embed="rId7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5" name="Google Shape;85;p18"/>
          <p:cNvSpPr txBox="1">
            <a:spLocks noGrp="1"/>
          </p:cNvSpPr>
          <p:nvPr>
            <p:ph type="body" idx="1"/>
          </p:nvPr>
        </p:nvSpPr>
        <p:spPr>
          <a:xfrm>
            <a:off x="4614065" y="85060"/>
            <a:ext cx="3856994" cy="5964865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dirty="0"/>
              <a:t>Suspect infant botulism in pediatric patients who present as </a:t>
            </a:r>
            <a:r>
              <a:rPr lang="en-US" b="1" dirty="0">
                <a:solidFill>
                  <a:srgbClr val="0070C0"/>
                </a:solidFill>
              </a:rPr>
              <a:t>“floppy” babies</a:t>
            </a:r>
            <a:r>
              <a:rPr lang="en-US" dirty="0"/>
              <a:t> with </a:t>
            </a:r>
            <a:r>
              <a:rPr lang="en-US" b="1" dirty="0">
                <a:solidFill>
                  <a:srgbClr val="0070C0"/>
                </a:solidFill>
              </a:rPr>
              <a:t>decreased tone, lethargy, and constipation.</a:t>
            </a:r>
          </a:p>
          <a:p>
            <a:pPr marL="274320" lvl="0" indent="0" defTabSz="914400">
              <a:spcBef>
                <a:spcPts val="0"/>
              </a:spcBef>
              <a:spcAft>
                <a:spcPts val="0"/>
              </a:spcAft>
              <a:buSzPct val="85000"/>
              <a:buNone/>
            </a:pPr>
            <a:endParaRPr lang="en-US" b="1" dirty="0">
              <a:solidFill>
                <a:srgbClr val="0070C0"/>
              </a:solidFill>
            </a:endParaRPr>
          </a:p>
          <a:p>
            <a:pPr marL="457200" lvl="0" indent="-182880" defTabSz="914400">
              <a:spcBef>
                <a:spcPts val="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dirty="0"/>
              <a:t>Routine laboratory studies are often normal; however, </a:t>
            </a:r>
            <a:r>
              <a:rPr lang="en-US" b="1" dirty="0">
                <a:solidFill>
                  <a:srgbClr val="0070C0"/>
                </a:solidFill>
              </a:rPr>
              <a:t>you may see sequela secondary to botulism toxin </a:t>
            </a:r>
            <a:r>
              <a:rPr lang="en-US" dirty="0"/>
              <a:t>(such as hypercapnia and dehydration).</a:t>
            </a:r>
          </a:p>
          <a:p>
            <a:pPr marL="274320" lvl="0" indent="0" defTabSz="914400">
              <a:spcBef>
                <a:spcPts val="0"/>
              </a:spcBef>
              <a:spcAft>
                <a:spcPts val="0"/>
              </a:spcAft>
              <a:buSzPct val="85000"/>
              <a:buNone/>
            </a:pPr>
            <a:endParaRPr lang="en-US" dirty="0"/>
          </a:p>
          <a:p>
            <a:pPr marL="457200" lvl="0" indent="-182880" defTabSz="914400">
              <a:spcBef>
                <a:spcPts val="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dirty="0"/>
              <a:t>Diagnosis needs to be confirmed by </a:t>
            </a:r>
            <a:r>
              <a:rPr lang="en-US" b="1" dirty="0">
                <a:solidFill>
                  <a:srgbClr val="0070C0"/>
                </a:solidFill>
              </a:rPr>
              <a:t>stool culture or direct toxin assay.</a:t>
            </a:r>
          </a:p>
          <a:p>
            <a:pPr marL="914400" lvl="1" indent="-182880" defTabSz="914400">
              <a:spcBef>
                <a:spcPts val="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dirty="0"/>
              <a:t>Direct toxin assay can be obtained from stool, serum, or gastric contents.</a:t>
            </a:r>
          </a:p>
          <a:p>
            <a:pPr marL="731520" lvl="1" indent="0" defTabSz="914400">
              <a:spcBef>
                <a:spcPts val="0"/>
              </a:spcBef>
              <a:spcAft>
                <a:spcPts val="0"/>
              </a:spcAft>
              <a:buSzPct val="85000"/>
              <a:buNone/>
            </a:pPr>
            <a:endParaRPr lang="en-US" dirty="0"/>
          </a:p>
          <a:p>
            <a:pPr marL="457200" lvl="0" indent="-182880" defTabSz="914400">
              <a:spcBef>
                <a:spcPts val="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r>
              <a:rPr lang="en-US" dirty="0"/>
              <a:t>The individual state health department or Centers for Disease Control (CDC) often performs the </a:t>
            </a:r>
            <a:r>
              <a:rPr lang="en-US" b="1" dirty="0">
                <a:solidFill>
                  <a:srgbClr val="0070C0"/>
                </a:solidFill>
              </a:rPr>
              <a:t>testing because it is not available at most hospitals.</a:t>
            </a:r>
          </a:p>
          <a:p>
            <a:pPr lvl="1" indent="-182880" defTabSz="914400">
              <a:buSzPct val="85000"/>
              <a:buFont typeface="Wingdings" pitchFamily="2" charset="2"/>
              <a:buChar char="§"/>
            </a:pPr>
            <a:r>
              <a:rPr lang="en-US" dirty="0"/>
              <a:t>It can take </a:t>
            </a:r>
            <a:r>
              <a:rPr lang="en-US" b="1" dirty="0">
                <a:solidFill>
                  <a:srgbClr val="0070C0"/>
                </a:solidFill>
              </a:rPr>
              <a:t>several days to result.</a:t>
            </a:r>
          </a:p>
          <a:p>
            <a:pPr marL="0" lvl="0" indent="-182880" defTabSz="914400">
              <a:spcBef>
                <a:spcPts val="1200"/>
              </a:spcBef>
              <a:spcAft>
                <a:spcPts val="0"/>
              </a:spcAft>
              <a:buSzPct val="85000"/>
              <a:buFont typeface="Wingdings" pitchFamily="2" charset="2"/>
              <a:buChar char="§"/>
            </a:pPr>
            <a:endParaRPr lang="en-US" dirty="0"/>
          </a:p>
          <a:p>
            <a:pPr marL="0" lvl="0" indent="-182880" defTabSz="914400">
              <a:spcBef>
                <a:spcPts val="1200"/>
              </a:spcBef>
              <a:spcAft>
                <a:spcPts val="1200"/>
              </a:spcAft>
              <a:buSzPct val="85000"/>
              <a:buFont typeface="Wingdings" pitchFamily="2" charset="2"/>
              <a:buChar char="§"/>
            </a:pPr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7" name="Group 96">
            <a:extLst>
              <a:ext uri="{FF2B5EF4-FFF2-40B4-BE49-F238E27FC236}">
                <a16:creationId xmlns:a16="http://schemas.microsoft.com/office/drawing/2014/main" id="{766238F3-962C-47EF-BBD1-CFC421D3B8F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15043D81-4F99-4570-96A8-0A787D43C2F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99" name="Oval 98">
              <a:extLst>
                <a:ext uri="{FF2B5EF4-FFF2-40B4-BE49-F238E27FC236}">
                  <a16:creationId xmlns:a16="http://schemas.microsoft.com/office/drawing/2014/main" id="{B115D4A1-FA42-4067-AACD-B5134F3C71E2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>
        <p:nvSpPr>
          <p:cNvPr id="90" name="Google Shape;90;p19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4800"/>
              <a:t>Differential Diagnosis</a:t>
            </a:r>
          </a:p>
        </p:txBody>
      </p:sp>
      <p:sp>
        <p:nvSpPr>
          <p:cNvPr id="108" name="Rectangle 100">
            <a:extLst>
              <a:ext uri="{FF2B5EF4-FFF2-40B4-BE49-F238E27FC236}">
                <a16:creationId xmlns:a16="http://schemas.microsoft.com/office/drawing/2014/main" id="{3DFE545D-86C5-4F48-897C-C3AA8FBE3DE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0100" y="1509969"/>
            <a:ext cx="7543800" cy="60513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09" name="Google Shape;91;p19">
            <a:extLst>
              <a:ext uri="{FF2B5EF4-FFF2-40B4-BE49-F238E27FC236}">
                <a16:creationId xmlns:a16="http://schemas.microsoft.com/office/drawing/2014/main" id="{2DBA8618-59BB-D4B6-17D7-829FFFB1A4A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90568977"/>
              </p:ext>
            </p:extLst>
          </p:nvPr>
        </p:nvGraphicFramePr>
        <p:xfrm>
          <a:off x="802481" y="1789042"/>
          <a:ext cx="7543800" cy="271338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Group 101">
            <a:extLst>
              <a:ext uri="{FF2B5EF4-FFF2-40B4-BE49-F238E27FC236}">
                <a16:creationId xmlns:a16="http://schemas.microsoft.com/office/drawing/2014/main" id="{132FD491-28F3-42E7-AEBF-A9E3C462C9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103" name="Oval 102">
              <a:extLst>
                <a:ext uri="{FF2B5EF4-FFF2-40B4-BE49-F238E27FC236}">
                  <a16:creationId xmlns:a16="http://schemas.microsoft.com/office/drawing/2014/main" id="{AD016B6E-F283-4CFB-9099-05C8DA6AB3F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104" name="Oval 103">
              <a:extLst>
                <a:ext uri="{FF2B5EF4-FFF2-40B4-BE49-F238E27FC236}">
                  <a16:creationId xmlns:a16="http://schemas.microsoft.com/office/drawing/2014/main" id="{72D0360E-345F-4790-B0A0-03ADC36B5E4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 useBgFill="1">
        <p:nvSpPr>
          <p:cNvPr id="106" name="Rectangle 105">
            <a:extLst>
              <a:ext uri="{FF2B5EF4-FFF2-40B4-BE49-F238E27FC236}">
                <a16:creationId xmlns:a16="http://schemas.microsoft.com/office/drawing/2014/main" id="{E009DD9B-5EE2-4C0D-8B2B-351C8C1022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4000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Rectangle 107">
            <a:extLst>
              <a:ext uri="{FF2B5EF4-FFF2-40B4-BE49-F238E27FC236}">
                <a16:creationId xmlns:a16="http://schemas.microsoft.com/office/drawing/2014/main" id="{E720DB99-7745-4E75-9D96-AAB6D55C531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348089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D68803C4-E159-4360-B7BB-74205C8F78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451464"/>
            <a:ext cx="7667244" cy="1039405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504B0465-3B07-49BF-BEA7-D8147624629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1528991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96" name="Google Shape;96;p20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3800" cap="all"/>
              <a:t>Diagnosis &amp; Management</a:t>
            </a:r>
          </a:p>
        </p:txBody>
      </p:sp>
      <p:sp>
        <p:nvSpPr>
          <p:cNvPr id="97" name="Google Shape;97;p20"/>
          <p:cNvSpPr txBox="1">
            <a:spLocks noGrp="1"/>
          </p:cNvSpPr>
          <p:nvPr>
            <p:ph type="body" idx="1"/>
          </p:nvPr>
        </p:nvSpPr>
        <p:spPr>
          <a:xfrm>
            <a:off x="372141" y="1570482"/>
            <a:ext cx="8304026" cy="3422783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rmAutofit fontScale="92500" lnSpcReduction="20000"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Infantile botulism is a </a:t>
            </a:r>
            <a:r>
              <a:rPr lang="en-US" sz="1300" b="1" dirty="0">
                <a:solidFill>
                  <a:srgbClr val="0070C0"/>
                </a:solidFill>
              </a:rPr>
              <a:t>clinical diagnosis</a:t>
            </a:r>
            <a:r>
              <a:rPr lang="en-US" sz="1300" dirty="0"/>
              <a:t> and should be managed based on history and physical exam while pending confirmatory test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b="1" i="1" dirty="0">
                <a:solidFill>
                  <a:srgbClr val="C00000"/>
                </a:solidFill>
              </a:rPr>
              <a:t>Do not wait for confirmatory tests to begin treatment. 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Physicians should contact the Infant Botulism Treatment and Prevent Program (IBTPP) to initiate the multidisciplinary decision regarding treatment.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If the IBTPP decides that infant botulism is a likely diagnosis, they arrange human botulism immune globulin intravenous (human BIG-IV) to be sent to the patient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Manage the </a:t>
            </a:r>
            <a:r>
              <a:rPr lang="en-US" sz="1300" b="1" dirty="0">
                <a:solidFill>
                  <a:srgbClr val="0070C0"/>
                </a:solidFill>
              </a:rPr>
              <a:t>patient’s A, B, C’s</a:t>
            </a:r>
            <a:r>
              <a:rPr lang="en-US" sz="1300" dirty="0"/>
              <a:t> as you normally would.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50% of infants will require intubation.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b="1" u="sng" dirty="0"/>
              <a:t>Pearl</a:t>
            </a:r>
            <a:r>
              <a:rPr lang="en-US" sz="1300" dirty="0"/>
              <a:t>: be sure to perform a neuro exam prior to intubation – there should be time to do so while equipment and medications are being set up. 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b="1" dirty="0">
                <a:solidFill>
                  <a:srgbClr val="0070C0"/>
                </a:solidFill>
              </a:rPr>
              <a:t>Supportive treatment: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Respiratory support, nutrition, and positioning.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Avoid medications that may potentiate neuromuscular weaknes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Order </a:t>
            </a:r>
            <a:r>
              <a:rPr lang="en-US" sz="1300" b="1" dirty="0">
                <a:solidFill>
                  <a:srgbClr val="0070C0"/>
                </a:solidFill>
              </a:rPr>
              <a:t>routine laboratory studies and urinalysis </a:t>
            </a:r>
            <a:r>
              <a:rPr lang="en-US" sz="1300" dirty="0"/>
              <a:t>to rule out other differential diagnose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b="1" dirty="0">
                <a:solidFill>
                  <a:srgbClr val="0070C0"/>
                </a:solidFill>
              </a:rPr>
              <a:t>No imaging is necessary for diagnosis</a:t>
            </a:r>
            <a:r>
              <a:rPr lang="en-US" sz="1300" dirty="0"/>
              <a:t> but patients often undergo CT head without contrast and CXRs to </a:t>
            </a:r>
            <a:r>
              <a:rPr lang="en-US" sz="1300" b="1" dirty="0">
                <a:solidFill>
                  <a:srgbClr val="0070C0"/>
                </a:solidFill>
              </a:rPr>
              <a:t>evaluate for intracranial mass/bleed and underlying respiratory infection, respectively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300" dirty="0"/>
              <a:t>Lumbar puncture is often performed to evaluate for meningitis. </a:t>
            </a:r>
          </a:p>
        </p:txBody>
      </p:sp>
      <p:sp>
        <p:nvSpPr>
          <p:cNvPr id="114" name="Oval 113">
            <a:extLst>
              <a:ext uri="{FF2B5EF4-FFF2-40B4-BE49-F238E27FC236}">
                <a16:creationId xmlns:a16="http://schemas.microsoft.com/office/drawing/2014/main" id="{49B7FFA5-14CB-4A4F-9BCC-CA3AA5D9D27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51293" y="4672260"/>
            <a:ext cx="342900" cy="342900"/>
          </a:xfrm>
          <a:prstGeom prst="ellipse">
            <a:avLst/>
          </a:prstGeom>
          <a:blipFill dpi="0" rotWithShape="1">
            <a:blip r:embed="rId3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rcRect/>
            <a:tile tx="50800" ty="0" sx="85000" sy="85000" flip="none" algn="tl"/>
          </a:blipFill>
          <a:ln w="25400" cap="flat" cmpd="sng" algn="ctr">
            <a:noFill/>
            <a:prstDash val="solid"/>
          </a:ln>
          <a:effectLst/>
        </p:spPr>
        <p:txBody>
          <a:bodyPr lIns="0" tIns="0" rIns="0" bIns="0"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0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Rockwell Extra Bold" pitchFamily="18" charset="0"/>
              <a:ea typeface="+mn-ea"/>
              <a:cs typeface="+mn-cs"/>
            </a:endParaRPr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04E48745-7512-4EC2-9E20-9092D12150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73188" y="4694155"/>
            <a:ext cx="299110" cy="299111"/>
          </a:xfrm>
          <a:prstGeom prst="ellipse">
            <a:avLst/>
          </a:prstGeom>
          <a:noFill/>
          <a:ln w="12700" cap="flat" cmpd="sng" algn="ctr">
            <a:solidFill>
              <a:srgbClr val="FFFFFF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64" name="Group 6163">
            <a:extLst>
              <a:ext uri="{FF2B5EF4-FFF2-40B4-BE49-F238E27FC236}">
                <a16:creationId xmlns:a16="http://schemas.microsoft.com/office/drawing/2014/main" id="{132FD491-28F3-42E7-AEBF-A9E3C462C92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551293" y="4672260"/>
            <a:ext cx="342900" cy="342900"/>
            <a:chOff x="11361456" y="6195813"/>
            <a:chExt cx="548640" cy="548640"/>
          </a:xfrm>
        </p:grpSpPr>
        <p:sp>
          <p:nvSpPr>
            <p:cNvPr id="6171" name="Oval 6164">
              <a:extLst>
                <a:ext uri="{FF2B5EF4-FFF2-40B4-BE49-F238E27FC236}">
                  <a16:creationId xmlns:a16="http://schemas.microsoft.com/office/drawing/2014/main" id="{AD016B6E-F283-4CFB-9099-05C8DA6AB3FB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61456" y="6195813"/>
              <a:ext cx="548640" cy="548640"/>
            </a:xfrm>
            <a:prstGeom prst="ellipse">
              <a:avLst/>
            </a:prstGeom>
            <a:blipFill dpi="0" rotWithShape="1">
              <a:blip r:embed="rId3">
                <a:duotone>
                  <a:schemeClr val="accent1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aturation sat="95000"/>
                        </a14:imgEffect>
                        <a14:imgEffect>
                          <a14:brightnessContrast bright="-40000" contrast="20000"/>
                        </a14:imgEffect>
                      </a14:imgLayer>
                    </a14:imgProps>
                  </a:ext>
                </a:extLst>
              </a:blip>
              <a:srcRect/>
              <a:tile tx="50800" ty="0" sx="85000" sy="85000" flip="none" algn="tl"/>
            </a:blipFill>
            <a:ln w="25400" cap="flat" cmpd="sng" algn="ctr">
              <a:noFill/>
              <a:prstDash val="solid"/>
            </a:ln>
            <a:effectLst/>
          </p:spPr>
        </p:sp>
        <p:sp>
          <p:nvSpPr>
            <p:cNvPr id="6166" name="Oval 6165">
              <a:extLst>
                <a:ext uri="{FF2B5EF4-FFF2-40B4-BE49-F238E27FC236}">
                  <a16:creationId xmlns:a16="http://schemas.microsoft.com/office/drawing/2014/main" id="{72D0360E-345F-4790-B0A0-03ADC36B5E4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11396488" y="6230844"/>
              <a:ext cx="478576" cy="478578"/>
            </a:xfrm>
            <a:prstGeom prst="ellipse">
              <a:avLst/>
            </a:prstGeom>
            <a:noFill/>
            <a:ln w="12700" cap="flat" cmpd="sng" algn="ctr">
              <a:solidFill>
                <a:srgbClr val="FFFFFF"/>
              </a:solidFill>
              <a:prstDash val="solid"/>
            </a:ln>
            <a:effectLst/>
          </p:spPr>
        </p:sp>
      </p:grpSp>
      <p:sp useBgFill="1">
        <p:nvSpPr>
          <p:cNvPr id="6168" name="Rectangle 6167">
            <a:extLst>
              <a:ext uri="{FF2B5EF4-FFF2-40B4-BE49-F238E27FC236}">
                <a16:creationId xmlns:a16="http://schemas.microsoft.com/office/drawing/2014/main" id="{E009DD9B-5EE2-4C0D-8B2B-351C8C10220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4000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70" name="Rectangle 6169">
            <a:extLst>
              <a:ext uri="{FF2B5EF4-FFF2-40B4-BE49-F238E27FC236}">
                <a16:creationId xmlns:a16="http://schemas.microsoft.com/office/drawing/2014/main" id="{E720DB99-7745-4E75-9D96-AAB6D55C531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348089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6200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172" name="Rectangle 6171">
            <a:extLst>
              <a:ext uri="{FF2B5EF4-FFF2-40B4-BE49-F238E27FC236}">
                <a16:creationId xmlns:a16="http://schemas.microsoft.com/office/drawing/2014/main" id="{D68803C4-E159-4360-B7BB-74205C8F782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451464"/>
            <a:ext cx="7667244" cy="1039405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048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6174" name="Rectangle 6173">
            <a:extLst>
              <a:ext uri="{FF2B5EF4-FFF2-40B4-BE49-F238E27FC236}">
                <a16:creationId xmlns:a16="http://schemas.microsoft.com/office/drawing/2014/main" id="{504B0465-3B07-49BF-BEA7-D8147624629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738378" y="1528991"/>
            <a:ext cx="7667244" cy="60512"/>
          </a:xfrm>
          <a:prstGeom prst="rect">
            <a:avLst/>
          </a:prstGeom>
          <a:blipFill dpi="0" rotWithShape="1">
            <a:blip r:embed="rId5">
              <a:alphaModFix amt="85000"/>
              <a:lum bright="70000" contrast="-70000"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6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tile tx="0" ty="-717550" sx="92000" sy="89000" flip="xy" algn="ctr"/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2" name="Google Shape;102;p21"/>
          <p:cNvSpPr txBox="1">
            <a:spLocks noGrp="1"/>
          </p:cNvSpPr>
          <p:nvPr>
            <p:ph type="title"/>
          </p:nvPr>
        </p:nvSpPr>
        <p:spPr>
          <a:xfrm>
            <a:off x="802386" y="363474"/>
            <a:ext cx="7543800" cy="1207008"/>
          </a:xfrm>
          <a:prstGeom prst="rect">
            <a:avLst/>
          </a:prstGeom>
        </p:spPr>
        <p:txBody>
          <a:bodyPr spcFirstLastPara="1" vert="horz" lIns="91440" tIns="45720" rIns="91440" bIns="45720" rtlCol="0" anchor="ctr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4600" cap="all"/>
              <a:t>What is “Baby BIG?”</a:t>
            </a:r>
          </a:p>
        </p:txBody>
      </p:sp>
      <p:sp>
        <p:nvSpPr>
          <p:cNvPr id="103" name="Google Shape;103;p21"/>
          <p:cNvSpPr txBox="1">
            <a:spLocks noGrp="1"/>
          </p:cNvSpPr>
          <p:nvPr>
            <p:ph type="body" idx="1"/>
          </p:nvPr>
        </p:nvSpPr>
        <p:spPr>
          <a:xfrm>
            <a:off x="802386" y="1740309"/>
            <a:ext cx="7543800" cy="2888840"/>
          </a:xfrm>
          <a:prstGeom prst="rect">
            <a:avLst/>
          </a:prstGeom>
        </p:spPr>
        <p:txBody>
          <a:bodyPr spcFirstLastPara="1" vert="horz" lIns="91440" tIns="45720" rIns="91440" bIns="45720" rtlCol="0" anchorCtr="0">
            <a:normAutofit fontScale="92500" lnSpcReduction="20000"/>
          </a:bodyPr>
          <a:lstStyle/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b="1" dirty="0">
                <a:solidFill>
                  <a:srgbClr val="0070C0"/>
                </a:solidFill>
              </a:rPr>
              <a:t>Botulism Immune Globulin Intravenous (Human) (BIG-IV)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AKA Baby BIG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Human-derived anti-botulism toxin antibodies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Food and Drug Administration (FDA) approved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b="1" dirty="0">
                <a:solidFill>
                  <a:srgbClr val="0070C0"/>
                </a:solidFill>
              </a:rPr>
              <a:t>Benefits</a:t>
            </a:r>
            <a:r>
              <a:rPr lang="en-US" sz="1400" dirty="0">
                <a:solidFill>
                  <a:srgbClr val="0070C0"/>
                </a:solidFill>
              </a:rPr>
              <a:t>: 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Decreases the </a:t>
            </a:r>
            <a:r>
              <a:rPr lang="en-US" sz="1400" b="1" dirty="0">
                <a:solidFill>
                  <a:srgbClr val="0070C0"/>
                </a:solidFill>
              </a:rPr>
              <a:t>length of hospital stay 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Decreases </a:t>
            </a:r>
            <a:r>
              <a:rPr lang="en-US" sz="1400" b="1" dirty="0">
                <a:solidFill>
                  <a:srgbClr val="0070C0"/>
                </a:solidFill>
              </a:rPr>
              <a:t>length of mechanical ventilation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Single dose treatment given intravenously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Can rapidly </a:t>
            </a:r>
            <a:r>
              <a:rPr lang="en-US" sz="1400" b="1" dirty="0">
                <a:solidFill>
                  <a:srgbClr val="0070C0"/>
                </a:solidFill>
              </a:rPr>
              <a:t>decrease duration of treatment </a:t>
            </a:r>
            <a:r>
              <a:rPr lang="en-US" sz="1400" dirty="0"/>
              <a:t>if given within the first 24 hours.</a:t>
            </a:r>
          </a:p>
          <a:p>
            <a:pPr marL="457200" lvl="0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b="1" dirty="0">
                <a:solidFill>
                  <a:srgbClr val="0070C0"/>
                </a:solidFill>
              </a:rPr>
              <a:t>Costs:</a:t>
            </a:r>
          </a:p>
          <a:p>
            <a:pPr marL="914400" lvl="1" indent="-182880" defTabSz="914400">
              <a:spcBef>
                <a:spcPts val="0"/>
              </a:spcBef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~$50,000</a:t>
            </a:r>
          </a:p>
          <a:p>
            <a:pPr indent="-182880" defTabSz="914400">
              <a:spcAft>
                <a:spcPts val="600"/>
              </a:spcAft>
              <a:buSzPct val="85000"/>
              <a:buFont typeface="Wingdings" pitchFamily="2" charset="2"/>
              <a:buChar char="§"/>
            </a:pPr>
            <a:r>
              <a:rPr lang="en-US" sz="1400" dirty="0"/>
              <a:t>The </a:t>
            </a:r>
            <a:r>
              <a:rPr lang="en-US" sz="1400" b="1" dirty="0">
                <a:solidFill>
                  <a:srgbClr val="0070C0"/>
                </a:solidFill>
              </a:rPr>
              <a:t>decision to administer </a:t>
            </a:r>
            <a:r>
              <a:rPr lang="en-US" sz="1400" dirty="0"/>
              <a:t>Human BIG-IV is a </a:t>
            </a:r>
            <a:r>
              <a:rPr lang="en-US" sz="1400" b="1" dirty="0">
                <a:solidFill>
                  <a:srgbClr val="0070C0"/>
                </a:solidFill>
              </a:rPr>
              <a:t>multidisciplinary process </a:t>
            </a:r>
            <a:r>
              <a:rPr lang="en-US" sz="1400" dirty="0"/>
              <a:t>overseen by the IBTPP.</a:t>
            </a:r>
          </a:p>
        </p:txBody>
      </p:sp>
      <p:sp>
        <p:nvSpPr>
          <p:cNvPr id="6176" name="Oval 6175">
            <a:extLst>
              <a:ext uri="{FF2B5EF4-FFF2-40B4-BE49-F238E27FC236}">
                <a16:creationId xmlns:a16="http://schemas.microsoft.com/office/drawing/2014/main" id="{49B7FFA5-14CB-4A4F-9BCC-CA3AA5D9D27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51293" y="4672260"/>
            <a:ext cx="342900" cy="342900"/>
          </a:xfrm>
          <a:prstGeom prst="ellipse">
            <a:avLst/>
          </a:prstGeom>
          <a:blipFill dpi="0" rotWithShape="1">
            <a:blip r:embed="rId3">
              <a:duotone>
                <a:schemeClr val="accent1">
                  <a:shade val="45000"/>
                  <a:satMod val="135000"/>
                </a:schemeClr>
                <a:prstClr val="white"/>
              </a:duotone>
            </a:blip>
            <a:srcRect/>
            <a:tile tx="50800" ty="0" sx="85000" sy="85000" flip="none" algn="tl"/>
          </a:blipFill>
          <a:ln w="25400" cap="flat" cmpd="sng" algn="ctr">
            <a:noFill/>
            <a:prstDash val="solid"/>
          </a:ln>
          <a:effectLst/>
        </p:spPr>
        <p:txBody>
          <a:bodyPr lIns="0" tIns="0" rIns="0" bIns="0"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20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Rockwell Extra Bold" pitchFamily="18" charset="0"/>
              <a:ea typeface="+mn-ea"/>
              <a:cs typeface="+mn-cs"/>
            </a:endParaRPr>
          </a:p>
        </p:txBody>
      </p:sp>
      <p:sp>
        <p:nvSpPr>
          <p:cNvPr id="6178" name="Oval 6177">
            <a:extLst>
              <a:ext uri="{FF2B5EF4-FFF2-40B4-BE49-F238E27FC236}">
                <a16:creationId xmlns:a16="http://schemas.microsoft.com/office/drawing/2014/main" id="{04E48745-7512-4EC2-9E20-9092D12150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573188" y="4694155"/>
            <a:ext cx="299110" cy="299111"/>
          </a:xfrm>
          <a:prstGeom prst="ellipse">
            <a:avLst/>
          </a:prstGeom>
          <a:noFill/>
          <a:ln w="12700" cap="flat" cmpd="sng" algn="ctr">
            <a:solidFill>
              <a:srgbClr val="FFFFFF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Wood Type">
  <a:themeElements>
    <a:clrScheme name="Wood Type">
      <a:dk1>
        <a:sysClr val="windowText" lastClr="000000"/>
      </a:dk1>
      <a:lt1>
        <a:sysClr val="window" lastClr="FFFFFF"/>
      </a:lt1>
      <a:dk2>
        <a:srgbClr val="775F55"/>
      </a:dk2>
      <a:lt2>
        <a:srgbClr val="EBDDC3"/>
      </a:lt2>
      <a:accent1>
        <a:srgbClr val="94B6D2"/>
      </a:accent1>
      <a:accent2>
        <a:srgbClr val="DD8047"/>
      </a:accent2>
      <a:accent3>
        <a:srgbClr val="A5AB81"/>
      </a:accent3>
      <a:accent4>
        <a:srgbClr val="D8B25C"/>
      </a:accent4>
      <a:accent5>
        <a:srgbClr val="7BA79D"/>
      </a:accent5>
      <a:accent6>
        <a:srgbClr val="968C8C"/>
      </a:accent6>
      <a:hlink>
        <a:srgbClr val="F7B615"/>
      </a:hlink>
      <a:folHlink>
        <a:srgbClr val="704404"/>
      </a:folHlink>
    </a:clrScheme>
    <a:fontScheme name="Wood Type">
      <a:majorFont>
        <a:latin typeface="Georgia" panose="02040502050405020303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rebuchet MS" panose="020B0603020202020204"/>
        <a:ea typeface=""/>
        <a:cs typeface=""/>
        <a:font script="Jpan" typeface="HG丸ｺﾞｼｯｸM-PRO"/>
        <a:font script="Hang" typeface="HY그래픽M"/>
        <a:font script="Hans" typeface="华文新魏"/>
        <a:font script="Hant" typeface="微軟正黑體"/>
        <a:font script="Arab" typeface="Tahoma"/>
        <a:font script="Hebr" typeface="Gisha"/>
        <a:font script="Thai" typeface="Iris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Wood Type">
      <a:fillStyleLst>
        <a:solidFill>
          <a:schemeClr val="phClr"/>
        </a:solidFill>
        <a:blipFill rotWithShape="1">
          <a:blip xmlns:r="http://schemas.openxmlformats.org/officeDocument/2006/relationships" r:embed="rId1">
            <a:duotone>
              <a:schemeClr val="phClr">
                <a:tint val="70000"/>
                <a:shade val="63000"/>
              </a:schemeClr>
              <a:schemeClr val="phClr">
                <a:tint val="10000"/>
                <a:satMod val="150000"/>
              </a:schemeClr>
            </a:duotone>
          </a:blip>
          <a:tile tx="0" ty="0" sx="60000" sy="59000" flip="none" algn="tl"/>
        </a:blipFill>
        <a:blipFill rotWithShape="1">
          <a:blip xmlns:r="http://schemas.openxmlformats.org/officeDocument/2006/relationships" r:embed="rId1">
            <a:duotone>
              <a:schemeClr val="phClr">
                <a:shade val="36000"/>
                <a:satMod val="120000"/>
              </a:schemeClr>
              <a:schemeClr val="phClr">
                <a:tint val="40000"/>
              </a:schemeClr>
            </a:duotone>
          </a:blip>
          <a:tile tx="0" ty="0" sx="60000" sy="59000" flip="none" algn="tl"/>
        </a:blip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softEdge rad="12700"/>
          </a:effectLst>
        </a:effectStyle>
        <a:effectStyle>
          <a:effectLst>
            <a:outerShdw blurRad="50800" dist="19050" dir="5400000" algn="tl" rotWithShape="0">
              <a:srgbClr val="000000">
                <a:alpha val="60000"/>
              </a:srgbClr>
            </a:outerShdw>
            <a:softEdge rad="12700"/>
          </a:effectLst>
        </a:effectStyle>
      </a:effectStyleLst>
      <a:bgFillStyleLst>
        <a:solidFill>
          <a:schemeClr val="phClr"/>
        </a:solidFill>
        <a:solidFill>
          <a:schemeClr val="phClr">
            <a:shade val="97000"/>
            <a:satMod val="150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75000"/>
                <a:shade val="58000"/>
                <a:satMod val="120000"/>
              </a:schemeClr>
              <a:schemeClr val="phClr">
                <a:tint val="50000"/>
                <a:shade val="96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ood Type" id="{7ACABC62-BF99-48CF-A9DC-4DB89C7B13DC}" vid="{C6AE0645-98FF-411B-B0E9-59ABD78A0CCE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{91F25C8E-0C46-8841-AC81-E6D2C9771348}tf10001070</Template>
  <TotalTime>156</TotalTime>
  <Words>1432</Words>
  <Application>Microsoft Macintosh PowerPoint</Application>
  <PresentationFormat>On-screen Show (16:9)</PresentationFormat>
  <Paragraphs>115</Paragraphs>
  <Slides>11</Slides>
  <Notes>1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Arial</vt:lpstr>
      <vt:lpstr>Calibri</vt:lpstr>
      <vt:lpstr>Georgia</vt:lpstr>
      <vt:lpstr>Rockwell Extra Bold</vt:lpstr>
      <vt:lpstr>Trebuchet MS</vt:lpstr>
      <vt:lpstr>Wingdings</vt:lpstr>
      <vt:lpstr>Wood Type</vt:lpstr>
      <vt:lpstr>Infant Botulism</vt:lpstr>
      <vt:lpstr>Infant Botulism - An Overview</vt:lpstr>
      <vt:lpstr>Pathophysiology</vt:lpstr>
      <vt:lpstr>Presentation</vt:lpstr>
      <vt:lpstr>Clues to the diagnosis!</vt:lpstr>
      <vt:lpstr>Evaluation</vt:lpstr>
      <vt:lpstr>Differential Diagnosis</vt:lpstr>
      <vt:lpstr>Diagnosis &amp; Management</vt:lpstr>
      <vt:lpstr>What is “Baby BIG?”</vt:lpstr>
      <vt:lpstr>Prognosis</vt:lpstr>
      <vt:lpstr>References: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antile Botulism</dc:title>
  <dc:creator>Linda Herman</dc:creator>
  <cp:lastModifiedBy>Toohey, Shannon</cp:lastModifiedBy>
  <cp:revision>11</cp:revision>
  <dcterms:modified xsi:type="dcterms:W3CDTF">2023-07-22T18:16:25Z</dcterms:modified>
</cp:coreProperties>
</file>